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78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ekle Pauzaite" userId="06f7e524-8501-4f81-9b2a-484f6f2c7061" providerId="ADAL" clId="{E54163B5-263A-464A-8812-9DEBC385B07B}"/>
    <pc:docChg chg="addSld modSld">
      <pc:chgData name="Tekle Pauzaite" userId="06f7e524-8501-4f81-9b2a-484f6f2c7061" providerId="ADAL" clId="{E54163B5-263A-464A-8812-9DEBC385B07B}" dt="2024-03-27T11:05:27.834" v="80" actId="167"/>
      <pc:docMkLst>
        <pc:docMk/>
      </pc:docMkLst>
      <pc:sldChg chg="addSp delSp modSp add">
        <pc:chgData name="Tekle Pauzaite" userId="06f7e524-8501-4f81-9b2a-484f6f2c7061" providerId="ADAL" clId="{E54163B5-263A-464A-8812-9DEBC385B07B}" dt="2024-03-27T11:05:27.834" v="80" actId="167"/>
        <pc:sldMkLst>
          <pc:docMk/>
          <pc:sldMk cId="203325691" sldId="256"/>
        </pc:sldMkLst>
        <pc:spChg chg="del">
          <ac:chgData name="Tekle Pauzaite" userId="06f7e524-8501-4f81-9b2a-484f6f2c7061" providerId="ADAL" clId="{E54163B5-263A-464A-8812-9DEBC385B07B}" dt="2024-03-27T11:01:37.968" v="1"/>
          <ac:spMkLst>
            <pc:docMk/>
            <pc:sldMk cId="203325691" sldId="256"/>
            <ac:spMk id="2" creationId="{36C9B547-A587-4A9E-9B23-FCBAE0FC78D5}"/>
          </ac:spMkLst>
        </pc:spChg>
        <pc:spChg chg="del">
          <ac:chgData name="Tekle Pauzaite" userId="06f7e524-8501-4f81-9b2a-484f6f2c7061" providerId="ADAL" clId="{E54163B5-263A-464A-8812-9DEBC385B07B}" dt="2024-03-27T11:01:37.968" v="1"/>
          <ac:spMkLst>
            <pc:docMk/>
            <pc:sldMk cId="203325691" sldId="256"/>
            <ac:spMk id="3" creationId="{477EF715-CC93-4198-B609-6705B5ED45CE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4" creationId="{CCF0EF0D-E25D-4487-8800-374F393F33C1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5" creationId="{A101D58E-CCBB-48DC-A636-7F424B63A38B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6" creationId="{0490C55C-481F-4348-9403-EF1E7C0A342E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7" creationId="{DEDED5FA-3F8E-45EC-A470-F020DA8E223B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8" creationId="{D058E431-945F-4905-A8A2-7DDABE241F4C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9" creationId="{9CF5EA6D-711E-469B-AB79-9102F31E32FE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1" creationId="{97C678FE-5424-4E4E-8689-2AF6DF4CDF58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3" creationId="{93A81E34-BBC7-4428-8BAA-08294754CAAD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4" creationId="{C4C33F19-1077-4DF4-87FA-BB1BC398C29D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5" creationId="{1FD3B7D5-C3F9-46AF-BBCB-E85CF5CA2B94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6" creationId="{ED476953-3325-4C31-BA97-6CB78A54874A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7" creationId="{A3DB05F2-B61F-4599-A112-D5F6CD791DC3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8" creationId="{1C67FE52-BD2D-49A9-9A6B-E82774EC008A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19" creationId="{1DE82CF0-7027-491F-B297-C5AA1390ECAC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0" creationId="{533B0EC6-2476-43FF-829E-3A60495ACAA7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1" creationId="{4F9C6A82-4D0F-41A7-9F5F-7AA274266FDB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2" creationId="{8363D60A-D0EF-4390-87A7-DE89993C5C01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3" creationId="{128B8CB3-34B7-4BED-8E54-29EAD35DDC1D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4" creationId="{7EAF98A8-9402-4399-8756-D0B0DF267C50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5" creationId="{0A874181-31F6-4A43-BBA6-A97DC4BABE4D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6" creationId="{FCA5B629-8F8C-4A66-8A89-C3CB48FB892A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7" creationId="{EE1C7CEB-FDB7-4ADA-ADFE-CCABA29F3FFC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28" creationId="{DC84BCC2-B2A9-4D3B-9017-FA580E237B60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31" creationId="{8A2AA2A5-1DF6-42FE-9692-3BDD887DE81D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32" creationId="{7FC29912-3C8F-484B-A709-CB48593F4133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33" creationId="{142B0DB7-C21F-4FB6-A9DB-08616D18A2C7}"/>
          </ac:spMkLst>
        </pc:spChg>
        <pc:spChg chg="add">
          <ac:chgData name="Tekle Pauzaite" userId="06f7e524-8501-4f81-9b2a-484f6f2c7061" providerId="ADAL" clId="{E54163B5-263A-464A-8812-9DEBC385B07B}" dt="2024-03-27T11:01:38.983" v="2"/>
          <ac:spMkLst>
            <pc:docMk/>
            <pc:sldMk cId="203325691" sldId="256"/>
            <ac:spMk id="36" creationId="{3475A83D-945E-4862-A9BF-6EEC875454A1}"/>
          </ac:spMkLst>
        </pc:spChg>
        <pc:spChg chg="add mod">
          <ac:chgData name="Tekle Pauzaite" userId="06f7e524-8501-4f81-9b2a-484f6f2c7061" providerId="ADAL" clId="{E54163B5-263A-464A-8812-9DEBC385B07B}" dt="2024-03-27T11:02:04.008" v="4" actId="1076"/>
          <ac:spMkLst>
            <pc:docMk/>
            <pc:sldMk cId="203325691" sldId="256"/>
            <ac:spMk id="37" creationId="{54D16704-FFE1-4159-B83C-D7099E70C0AF}"/>
          </ac:spMkLst>
        </pc:spChg>
        <pc:spChg chg="add mod">
          <ac:chgData name="Tekle Pauzaite" userId="06f7e524-8501-4f81-9b2a-484f6f2c7061" providerId="ADAL" clId="{E54163B5-263A-464A-8812-9DEBC385B07B}" dt="2024-03-27T11:02:04.008" v="4" actId="1076"/>
          <ac:spMkLst>
            <pc:docMk/>
            <pc:sldMk cId="203325691" sldId="256"/>
            <ac:spMk id="38" creationId="{D6D868C4-D089-474D-BF1F-EC431464F935}"/>
          </ac:spMkLst>
        </pc:spChg>
        <pc:spChg chg="add mod">
          <ac:chgData name="Tekle Pauzaite" userId="06f7e524-8501-4f81-9b2a-484f6f2c7061" providerId="ADAL" clId="{E54163B5-263A-464A-8812-9DEBC385B07B}" dt="2024-03-27T11:02:04.008" v="4" actId="1076"/>
          <ac:spMkLst>
            <pc:docMk/>
            <pc:sldMk cId="203325691" sldId="256"/>
            <ac:spMk id="39" creationId="{9BAD2D59-0F71-43E9-8D0C-81650E2A5FA8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2" creationId="{739E655E-026E-4A11-A2F0-455928F1ED4B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3" creationId="{AFD34BEA-65CD-4AD4-AA9B-16EC868375BE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5" creationId="{14D3DC09-97E6-426B-B034-4BFF9BAA0811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6" creationId="{72F7D465-44D5-48E2-AB27-AD3680BC2CF6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7" creationId="{9F1E2FD6-0EFE-46FC-900D-E7CC0C5CAC4A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48" creationId="{B46775DA-7B1D-4ACF-B1A6-C9703AA2BCB6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1" creationId="{4A798A98-F217-4C90-BDFA-3405B7816898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2" creationId="{7F0FB564-9EA5-4A4B-B977-E77D95129981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3" creationId="{C53D99AF-D5A7-4668-A052-930E398A074E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4" creationId="{93F47AC2-ACA2-4616-9AD6-686407393944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5" creationId="{F8AFF98B-413E-4A12-AC4B-1BFCE26533D0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6" creationId="{F0B9C676-CF96-438B-B946-9E28320E49C0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7" creationId="{9DD34190-F1B6-43D9-8A2A-31C9FA2D81AB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8" creationId="{85E4FD59-D3B2-4737-A044-361E962C77C6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59" creationId="{E74FD5B7-0030-40F0-9D32-4358F561BDEC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0" creationId="{752EC273-8C16-46C7-946F-6497A86BE516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1" creationId="{1B32E860-B2BA-440C-ACDD-3BF5AF90EE8B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2" creationId="{4E89AF2B-050E-43DF-8BCC-6EEED5A63CDB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3" creationId="{890FBA3F-5103-41A8-B246-7FBE16C34EA2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4" creationId="{E52E709F-02C6-44FC-B3D8-5DB535233CA9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5" creationId="{0EC4E9E5-CD60-4EB6-B32A-815EC216C2CF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6" creationId="{54F0FAB6-F851-42C5-8CF1-6C1F4925E4CC}"/>
          </ac:spMkLst>
        </pc:spChg>
        <pc:spChg chg="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67" creationId="{C0046532-D5E9-410B-838B-856965E8F10F}"/>
          </ac:spMkLst>
        </pc:spChg>
        <pc:spChg chg="add mod">
          <ac:chgData name="Tekle Pauzaite" userId="06f7e524-8501-4f81-9b2a-484f6f2c7061" providerId="ADAL" clId="{E54163B5-263A-464A-8812-9DEBC385B07B}" dt="2024-03-27T11:02:04.008" v="4" actId="1076"/>
          <ac:spMkLst>
            <pc:docMk/>
            <pc:sldMk cId="203325691" sldId="256"/>
            <ac:spMk id="70" creationId="{A2D7228F-591B-4455-BEED-F1739DBCE1BB}"/>
          </ac:spMkLst>
        </pc:spChg>
        <pc:spChg chg="add mod">
          <ac:chgData name="Tekle Pauzaite" userId="06f7e524-8501-4f81-9b2a-484f6f2c7061" providerId="ADAL" clId="{E54163B5-263A-464A-8812-9DEBC385B07B}" dt="2024-03-27T11:04:13.662" v="63" actId="208"/>
          <ac:spMkLst>
            <pc:docMk/>
            <pc:sldMk cId="203325691" sldId="256"/>
            <ac:spMk id="75" creationId="{E540BCA3-11F7-4ED6-957A-BB15890BAF38}"/>
          </ac:spMkLst>
        </pc:spChg>
        <pc:spChg chg="add mod">
          <ac:chgData name="Tekle Pauzaite" userId="06f7e524-8501-4f81-9b2a-484f6f2c7061" providerId="ADAL" clId="{E54163B5-263A-464A-8812-9DEBC385B07B}" dt="2024-03-27T11:04:21.486" v="65" actId="14100"/>
          <ac:spMkLst>
            <pc:docMk/>
            <pc:sldMk cId="203325691" sldId="256"/>
            <ac:spMk id="76" creationId="{7987A85D-1847-4A1C-BACC-A42C1C326DCD}"/>
          </ac:spMkLst>
        </pc:spChg>
        <pc:spChg chg="add mod">
          <ac:chgData name="Tekle Pauzaite" userId="06f7e524-8501-4f81-9b2a-484f6f2c7061" providerId="ADAL" clId="{E54163B5-263A-464A-8812-9DEBC385B07B}" dt="2024-03-27T11:04:38.533" v="72" actId="1035"/>
          <ac:spMkLst>
            <pc:docMk/>
            <pc:sldMk cId="203325691" sldId="256"/>
            <ac:spMk id="77" creationId="{36D956B8-858D-4EE7-88C8-DACE26C957E7}"/>
          </ac:spMkLst>
        </pc:spChg>
        <pc:spChg chg="add mod">
          <ac:chgData name="Tekle Pauzaite" userId="06f7e524-8501-4f81-9b2a-484f6f2c7061" providerId="ADAL" clId="{E54163B5-263A-464A-8812-9DEBC385B07B}" dt="2024-03-27T11:04:45.550" v="73" actId="571"/>
          <ac:spMkLst>
            <pc:docMk/>
            <pc:sldMk cId="203325691" sldId="256"/>
            <ac:spMk id="78" creationId="{1F8E30D5-0290-4E57-9C3E-E750E1A14923}"/>
          </ac:spMkLst>
        </pc:spChg>
        <pc:spChg chg="add mod">
          <ac:chgData name="Tekle Pauzaite" userId="06f7e524-8501-4f81-9b2a-484f6f2c7061" providerId="ADAL" clId="{E54163B5-263A-464A-8812-9DEBC385B07B}" dt="2024-03-27T11:05:02.511" v="74" actId="571"/>
          <ac:spMkLst>
            <pc:docMk/>
            <pc:sldMk cId="203325691" sldId="256"/>
            <ac:spMk id="79" creationId="{F9925C89-6632-4F83-BA87-5708BE50C3A1}"/>
          </ac:spMkLst>
        </pc:spChg>
        <pc:spChg chg="add mod">
          <ac:chgData name="Tekle Pauzaite" userId="06f7e524-8501-4f81-9b2a-484f6f2c7061" providerId="ADAL" clId="{E54163B5-263A-464A-8812-9DEBC385B07B}" dt="2024-03-27T11:05:08.246" v="75" actId="571"/>
          <ac:spMkLst>
            <pc:docMk/>
            <pc:sldMk cId="203325691" sldId="256"/>
            <ac:spMk id="80" creationId="{E8CA1C0B-0060-4688-9D0D-440D31A13EEB}"/>
          </ac:spMkLst>
        </pc:spChg>
        <pc:spChg chg="add 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81" creationId="{B1F158D1-78CD-453C-9B0D-DAD768512ADC}"/>
          </ac:spMkLst>
        </pc:spChg>
        <pc:spChg chg="add mod topLvl">
          <ac:chgData name="Tekle Pauzaite" userId="06f7e524-8501-4f81-9b2a-484f6f2c7061" providerId="ADAL" clId="{E54163B5-263A-464A-8812-9DEBC385B07B}" dt="2024-03-27T11:05:22.536" v="78" actId="165"/>
          <ac:spMkLst>
            <pc:docMk/>
            <pc:sldMk cId="203325691" sldId="256"/>
            <ac:spMk id="82" creationId="{F47F5797-FB5A-408F-A669-823E35A7B654}"/>
          </ac:spMkLst>
        </pc:spChg>
        <pc:grpChg chg="add del mod">
          <ac:chgData name="Tekle Pauzaite" userId="06f7e524-8501-4f81-9b2a-484f6f2c7061" providerId="ADAL" clId="{E54163B5-263A-464A-8812-9DEBC385B07B}" dt="2024-03-27T11:05:22.536" v="78" actId="165"/>
          <ac:grpSpMkLst>
            <pc:docMk/>
            <pc:sldMk cId="203325691" sldId="256"/>
            <ac:grpSpMk id="40" creationId="{0D418DBE-3078-4A40-853D-14E26130965B}"/>
          </ac:grpSpMkLst>
        </pc:grpChg>
        <pc:picChg chg="add">
          <ac:chgData name="Tekle Pauzaite" userId="06f7e524-8501-4f81-9b2a-484f6f2c7061" providerId="ADAL" clId="{E54163B5-263A-464A-8812-9DEBC385B07B}" dt="2024-03-27T11:01:38.983" v="2"/>
          <ac:picMkLst>
            <pc:docMk/>
            <pc:sldMk cId="203325691" sldId="256"/>
            <ac:picMk id="29" creationId="{DACA3AE1-A681-48F2-A062-5CA73A10FC5F}"/>
          </ac:picMkLst>
        </pc:picChg>
        <pc:picChg chg="add">
          <ac:chgData name="Tekle Pauzaite" userId="06f7e524-8501-4f81-9b2a-484f6f2c7061" providerId="ADAL" clId="{E54163B5-263A-464A-8812-9DEBC385B07B}" dt="2024-03-27T11:01:38.983" v="2"/>
          <ac:picMkLst>
            <pc:docMk/>
            <pc:sldMk cId="203325691" sldId="256"/>
            <ac:picMk id="30" creationId="{9DAFD580-061A-47F2-A319-2907674A4599}"/>
          </ac:picMkLst>
        </pc:picChg>
        <pc:picChg chg="mod topLvl">
          <ac:chgData name="Tekle Pauzaite" userId="06f7e524-8501-4f81-9b2a-484f6f2c7061" providerId="ADAL" clId="{E54163B5-263A-464A-8812-9DEBC385B07B}" dt="2024-03-27T11:05:22.536" v="78" actId="165"/>
          <ac:picMkLst>
            <pc:docMk/>
            <pc:sldMk cId="203325691" sldId="256"/>
            <ac:picMk id="41" creationId="{8DA3138D-8327-44E8-8C82-E954FF63936D}"/>
          </ac:picMkLst>
        </pc:picChg>
        <pc:picChg chg="mod topLvl">
          <ac:chgData name="Tekle Pauzaite" userId="06f7e524-8501-4f81-9b2a-484f6f2c7061" providerId="ADAL" clId="{E54163B5-263A-464A-8812-9DEBC385B07B}" dt="2024-03-27T11:05:22.536" v="78" actId="165"/>
          <ac:picMkLst>
            <pc:docMk/>
            <pc:sldMk cId="203325691" sldId="256"/>
            <ac:picMk id="44" creationId="{29921129-A367-41D7-B58F-AB24A1689A34}"/>
          </ac:picMkLst>
        </pc:picChg>
        <pc:picChg chg="add mod modCrop">
          <ac:chgData name="Tekle Pauzaite" userId="06f7e524-8501-4f81-9b2a-484f6f2c7061" providerId="ADAL" clId="{E54163B5-263A-464A-8812-9DEBC385B07B}" dt="2024-03-27T11:02:42.462" v="19" actId="1076"/>
          <ac:picMkLst>
            <pc:docMk/>
            <pc:sldMk cId="203325691" sldId="256"/>
            <ac:picMk id="71" creationId="{B2DE2E4B-C9C7-4674-ACC2-8FF8ACB1B045}"/>
          </ac:picMkLst>
        </pc:picChg>
        <pc:picChg chg="add mod modCrop">
          <ac:chgData name="Tekle Pauzaite" userId="06f7e524-8501-4f81-9b2a-484f6f2c7061" providerId="ADAL" clId="{E54163B5-263A-464A-8812-9DEBC385B07B}" dt="2024-03-27T11:03:01.070" v="30" actId="1076"/>
          <ac:picMkLst>
            <pc:docMk/>
            <pc:sldMk cId="203325691" sldId="256"/>
            <ac:picMk id="72" creationId="{867C5C5E-7C13-45D5-83A7-5946D12F2294}"/>
          </ac:picMkLst>
        </pc:picChg>
        <pc:picChg chg="add mod ord modCrop">
          <ac:chgData name="Tekle Pauzaite" userId="06f7e524-8501-4f81-9b2a-484f6f2c7061" providerId="ADAL" clId="{E54163B5-263A-464A-8812-9DEBC385B07B}" dt="2024-03-27T11:05:26.002" v="79" actId="167"/>
          <ac:picMkLst>
            <pc:docMk/>
            <pc:sldMk cId="203325691" sldId="256"/>
            <ac:picMk id="73" creationId="{FE579EC1-5328-4759-A5AD-5CB70D7D96D9}"/>
          </ac:picMkLst>
        </pc:picChg>
        <pc:picChg chg="add mod ord modCrop">
          <ac:chgData name="Tekle Pauzaite" userId="06f7e524-8501-4f81-9b2a-484f6f2c7061" providerId="ADAL" clId="{E54163B5-263A-464A-8812-9DEBC385B07B}" dt="2024-03-27T11:05:27.834" v="80" actId="167"/>
          <ac:picMkLst>
            <pc:docMk/>
            <pc:sldMk cId="203325691" sldId="256"/>
            <ac:picMk id="74" creationId="{180FAA85-93ED-4D0F-97CD-7592201399ED}"/>
          </ac:picMkLst>
        </pc:picChg>
        <pc:cxnChg chg="add">
          <ac:chgData name="Tekle Pauzaite" userId="06f7e524-8501-4f81-9b2a-484f6f2c7061" providerId="ADAL" clId="{E54163B5-263A-464A-8812-9DEBC385B07B}" dt="2024-03-27T11:01:38.983" v="2"/>
          <ac:cxnSpMkLst>
            <pc:docMk/>
            <pc:sldMk cId="203325691" sldId="256"/>
            <ac:cxnSpMk id="10" creationId="{5DC27655-A531-4142-890C-2A36FD0B68CB}"/>
          </ac:cxnSpMkLst>
        </pc:cxnChg>
        <pc:cxnChg chg="add">
          <ac:chgData name="Tekle Pauzaite" userId="06f7e524-8501-4f81-9b2a-484f6f2c7061" providerId="ADAL" clId="{E54163B5-263A-464A-8812-9DEBC385B07B}" dt="2024-03-27T11:01:38.983" v="2"/>
          <ac:cxnSpMkLst>
            <pc:docMk/>
            <pc:sldMk cId="203325691" sldId="256"/>
            <ac:cxnSpMk id="12" creationId="{0083257C-F190-4F45-A397-9D7689222743}"/>
          </ac:cxnSpMkLst>
        </pc:cxnChg>
        <pc:cxnChg chg="add">
          <ac:chgData name="Tekle Pauzaite" userId="06f7e524-8501-4f81-9b2a-484f6f2c7061" providerId="ADAL" clId="{E54163B5-263A-464A-8812-9DEBC385B07B}" dt="2024-03-27T11:01:38.983" v="2"/>
          <ac:cxnSpMkLst>
            <pc:docMk/>
            <pc:sldMk cId="203325691" sldId="256"/>
            <ac:cxnSpMk id="34" creationId="{D06B2955-3E19-4F75-8CE9-9B6DCDE535C3}"/>
          </ac:cxnSpMkLst>
        </pc:cxnChg>
        <pc:cxnChg chg="add">
          <ac:chgData name="Tekle Pauzaite" userId="06f7e524-8501-4f81-9b2a-484f6f2c7061" providerId="ADAL" clId="{E54163B5-263A-464A-8812-9DEBC385B07B}" dt="2024-03-27T11:01:38.983" v="2"/>
          <ac:cxnSpMkLst>
            <pc:docMk/>
            <pc:sldMk cId="203325691" sldId="256"/>
            <ac:cxnSpMk id="35" creationId="{8E3B2768-441B-46F3-BB08-F193BBFD46CE}"/>
          </ac:cxnSpMkLst>
        </pc:cxnChg>
        <pc:cxnChg chg="mod topLvl">
          <ac:chgData name="Tekle Pauzaite" userId="06f7e524-8501-4f81-9b2a-484f6f2c7061" providerId="ADAL" clId="{E54163B5-263A-464A-8812-9DEBC385B07B}" dt="2024-03-27T11:05:22.536" v="78" actId="165"/>
          <ac:cxnSpMkLst>
            <pc:docMk/>
            <pc:sldMk cId="203325691" sldId="256"/>
            <ac:cxnSpMk id="49" creationId="{0052B02D-79EA-4D96-A0AB-2A278D38204A}"/>
          </ac:cxnSpMkLst>
        </pc:cxnChg>
        <pc:cxnChg chg="mod topLvl">
          <ac:chgData name="Tekle Pauzaite" userId="06f7e524-8501-4f81-9b2a-484f6f2c7061" providerId="ADAL" clId="{E54163B5-263A-464A-8812-9DEBC385B07B}" dt="2024-03-27T11:05:22.536" v="78" actId="165"/>
          <ac:cxnSpMkLst>
            <pc:docMk/>
            <pc:sldMk cId="203325691" sldId="256"/>
            <ac:cxnSpMk id="50" creationId="{A464202C-2E9C-46F2-BEDB-2EE5948521A1}"/>
          </ac:cxnSpMkLst>
        </pc:cxnChg>
        <pc:cxnChg chg="mod topLvl">
          <ac:chgData name="Tekle Pauzaite" userId="06f7e524-8501-4f81-9b2a-484f6f2c7061" providerId="ADAL" clId="{E54163B5-263A-464A-8812-9DEBC385B07B}" dt="2024-03-27T11:05:22.536" v="78" actId="165"/>
          <ac:cxnSpMkLst>
            <pc:docMk/>
            <pc:sldMk cId="203325691" sldId="256"/>
            <ac:cxnSpMk id="68" creationId="{3DEE365E-EEA5-4B54-9CD4-C5C07D18599F}"/>
          </ac:cxnSpMkLst>
        </pc:cxnChg>
        <pc:cxnChg chg="mod topLvl">
          <ac:chgData name="Tekle Pauzaite" userId="06f7e524-8501-4f81-9b2a-484f6f2c7061" providerId="ADAL" clId="{E54163B5-263A-464A-8812-9DEBC385B07B}" dt="2024-03-27T11:05:22.536" v="78" actId="165"/>
          <ac:cxnSpMkLst>
            <pc:docMk/>
            <pc:sldMk cId="203325691" sldId="256"/>
            <ac:cxnSpMk id="69" creationId="{E633AAE6-2937-4F1B-A607-2DE6BE831F1A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569ECB-FF48-40B4-85D4-A32A0A65CB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F4D729-8BE7-435C-B2D5-8EC4D01BA0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E43479-77C8-4CDE-A297-3C14C3696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C2AFDA-43A8-443C-8586-52F87FD9A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4A17D1-0ADB-47E9-A365-AC74CE650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386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10ED5D-B389-490C-9865-42F0788468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CB5594-ADE1-4D01-898A-E13129599C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125BA5-1362-4192-9508-D09B326CB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EF317F-5016-47FD-B85D-E774EE5600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431298-4B3D-4780-9077-38FB74905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3888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BFF4554-82CE-4A40-B86D-71DE2F4E00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ABF518-6F8D-4897-982C-9E08EA914D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B444DF-ECDD-42B4-9B6D-9F85346418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E2B872-7E6B-4B65-8BE6-40CD2C9CB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6B3B14-7199-4AE8-967E-A5BF820F4F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9224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3011EE-34C5-41AA-9582-8E81374851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5AB248-297D-4EED-8286-68E654E370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E18561-4090-44FE-9564-F232A1A56B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D49382-553A-45A9-9ABF-9DE451F51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7C369D-CA2D-42CC-9F7A-786482B943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6650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98688C-A853-47AD-B538-85F831B5C1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D2358A-0896-4CC8-99E7-9528D826C6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0F35D3-E6C0-4DF2-A18D-FE76602DB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92443D-85A3-4B87-9A5A-DA0E37E65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9E4180-DBD0-42E1-A2FE-9E25AB87F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2569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87B36B-C82D-43AD-9FFB-88193F488F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409756-4FE8-483E-8263-A9A89DD99B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70EEDE-2B1E-4D29-8359-C3F83188AF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2F9865-379C-410A-AD29-786887E45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02AF41-7C53-4655-81AD-1AACBDC71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A3027C-E6BF-417D-BB84-0F52DB36E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893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5EF039-CF9E-49A7-B1BB-CA796F853A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C10078-DFDF-498B-AACD-5386F07E10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4E74C7-2EDF-463B-9B6D-549B558D18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D91C2A-C53F-47E6-BEC5-B7C38A885C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3BFBB9-756D-4394-9AB3-0E5D1D1A32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A1FB05-AC3E-4AE9-AF0A-A2C29AD82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7CF016-1273-47E9-9319-343B0A607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264A28-ADCA-441F-B984-7141C5CE7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4759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4CE218-9B63-4305-AC66-DEE4F6D7FD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F37E9B-6729-4356-ADFA-D023958A2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F33D06E-3858-4BCE-90A2-40F418BF5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13E3791-38B1-47A7-98A8-A42E28F6A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1196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D833867-2585-4F6B-B1DD-1F69FA245C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5B5ED9-B716-4F6F-A470-7E58EE9C1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892CAD-ABE0-4140-A1D5-A2EC94B4E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5701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C1346-82C4-4556-B75C-042793DFFB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C272B9-55A7-4FBD-8332-3DF41D7227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AB5C1D-B75B-4572-A889-CCF1D3479A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C50D73-C227-4619-A302-5582DD6A7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900CCA-A26F-4AA3-BE89-1E81D0027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99F2DD-6DA6-443D-9045-75A577DF0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8562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A5E32-B45A-4C12-A4B0-582B336BD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366521A-C5F6-4BEF-8706-640A9AE456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5C34EC-8703-485C-A02B-87941C2D72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D3BF7C-FDB4-4692-9C51-DCBD2E26E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B98AC9-787D-4869-B21C-5FBC3E8674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132886-D15A-475D-B335-064F783CE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1472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7D1940E-B9FB-46A3-B2E3-6C0FF94319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01D88E-300E-4DD4-8740-3B93870E70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5ADA9E-89B4-4D49-9DEC-249A9D9EF6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6004EE-3987-426A-9850-C4A8FD39DB2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41B774-D54F-405F-99EA-6A7ADB6969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270236-09FA-48A7-A25D-AD8571560F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AD4EF2-AA88-476B-8BAD-F1D3DBFB9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0199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5" Type="http://schemas.openxmlformats.org/officeDocument/2006/relationships/image" Target="../media/image7.jp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g"/><Relationship Id="rId5" Type="http://schemas.openxmlformats.org/officeDocument/2006/relationships/image" Target="../media/image14.jpg"/><Relationship Id="rId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1DC3488-D7A1-E8E9-D1F0-710880A585AB}"/>
              </a:ext>
            </a:extLst>
          </p:cNvPr>
          <p:cNvSpPr txBox="1"/>
          <p:nvPr/>
        </p:nvSpPr>
        <p:spPr>
          <a:xfrm>
            <a:off x="363475" y="29827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2946587-EC45-4853-2FFD-BC36274CB66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466" t="18354" r="15172" b="54880"/>
          <a:stretch/>
        </p:blipFill>
        <p:spPr>
          <a:xfrm rot="16200000">
            <a:off x="1249236" y="528800"/>
            <a:ext cx="255237" cy="15314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895EF5A-0167-3886-5727-087DBA6B13E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76" t="17206" r="54362" b="56028"/>
          <a:stretch/>
        </p:blipFill>
        <p:spPr>
          <a:xfrm rot="16200000">
            <a:off x="1249236" y="229434"/>
            <a:ext cx="255237" cy="15314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9A7C3B3-41AF-316B-D2D6-9C76A891CD65}"/>
              </a:ext>
            </a:extLst>
          </p:cNvPr>
          <p:cNvSpPr txBox="1"/>
          <p:nvPr/>
        </p:nvSpPr>
        <p:spPr>
          <a:xfrm>
            <a:off x="2093205" y="1145286"/>
            <a:ext cx="5662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62D1094-75EA-EE87-A396-072838C55232}"/>
              </a:ext>
            </a:extLst>
          </p:cNvPr>
          <p:cNvSpPr txBox="1"/>
          <p:nvPr/>
        </p:nvSpPr>
        <p:spPr>
          <a:xfrm>
            <a:off x="2093205" y="865165"/>
            <a:ext cx="390052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C54075A-949B-EBF4-9209-153EC127C80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836" t="24502" r="24470" b="22405"/>
          <a:stretch/>
        </p:blipFill>
        <p:spPr>
          <a:xfrm rot="16200000">
            <a:off x="1266421" y="811909"/>
            <a:ext cx="221797" cy="15304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57DD199-006D-6FF1-491B-57B8CF81BDBE}"/>
              </a:ext>
            </a:extLst>
          </p:cNvPr>
          <p:cNvSpPr txBox="1"/>
          <p:nvPr/>
        </p:nvSpPr>
        <p:spPr>
          <a:xfrm>
            <a:off x="2093205" y="1466602"/>
            <a:ext cx="383233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186D15A-F1D8-1784-5CF3-3104ED59A90D}"/>
              </a:ext>
            </a:extLst>
          </p:cNvPr>
          <p:cNvSpPr txBox="1"/>
          <p:nvPr/>
        </p:nvSpPr>
        <p:spPr>
          <a:xfrm>
            <a:off x="2040540" y="657889"/>
            <a:ext cx="566212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 Hr 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B85083F-0C75-348F-2857-477CE14A85F1}"/>
              </a:ext>
            </a:extLst>
          </p:cNvPr>
          <p:cNvSpPr txBox="1"/>
          <p:nvPr/>
        </p:nvSpPr>
        <p:spPr>
          <a:xfrm>
            <a:off x="585053" y="664400"/>
            <a:ext cx="158203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20D75A8-252B-6706-0493-7A1BA236259B}"/>
              </a:ext>
            </a:extLst>
          </p:cNvPr>
          <p:cNvSpPr txBox="1"/>
          <p:nvPr/>
        </p:nvSpPr>
        <p:spPr>
          <a:xfrm>
            <a:off x="761452" y="664400"/>
            <a:ext cx="158203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B4A7CF9-DB28-BF4B-3E54-E7B7926A0490}"/>
              </a:ext>
            </a:extLst>
          </p:cNvPr>
          <p:cNvSpPr txBox="1"/>
          <p:nvPr/>
        </p:nvSpPr>
        <p:spPr>
          <a:xfrm>
            <a:off x="957768" y="664400"/>
            <a:ext cx="178660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9111079-A179-4468-6DEC-7754A0242215}"/>
              </a:ext>
            </a:extLst>
          </p:cNvPr>
          <p:cNvSpPr txBox="1"/>
          <p:nvPr/>
        </p:nvSpPr>
        <p:spPr>
          <a:xfrm>
            <a:off x="740089" y="486762"/>
            <a:ext cx="312768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541E9010-21E7-D880-8730-602F26A39A70}"/>
              </a:ext>
            </a:extLst>
          </p:cNvPr>
          <p:cNvCxnSpPr/>
          <p:nvPr/>
        </p:nvCxnSpPr>
        <p:spPr>
          <a:xfrm>
            <a:off x="636666" y="707921"/>
            <a:ext cx="622487" cy="20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DFF767AA-7186-A33C-BE6F-9D7E12930E47}"/>
              </a:ext>
            </a:extLst>
          </p:cNvPr>
          <p:cNvSpPr txBox="1"/>
          <p:nvPr/>
        </p:nvSpPr>
        <p:spPr>
          <a:xfrm>
            <a:off x="1423192" y="491411"/>
            <a:ext cx="490065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IP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84F7391-2DB1-E16A-8AAB-0A1876C02E55}"/>
              </a:ext>
            </a:extLst>
          </p:cNvPr>
          <p:cNvCxnSpPr/>
          <p:nvPr/>
        </p:nvCxnSpPr>
        <p:spPr>
          <a:xfrm>
            <a:off x="1405309" y="707921"/>
            <a:ext cx="622487" cy="20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86357475-24FC-AE0B-1224-425A582C11F4}"/>
              </a:ext>
            </a:extLst>
          </p:cNvPr>
          <p:cNvSpPr txBox="1"/>
          <p:nvPr/>
        </p:nvSpPr>
        <p:spPr>
          <a:xfrm>
            <a:off x="1134167" y="664400"/>
            <a:ext cx="178660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587B616-13D2-299D-E6EA-03E7C62A3B3E}"/>
              </a:ext>
            </a:extLst>
          </p:cNvPr>
          <p:cNvSpPr txBox="1"/>
          <p:nvPr/>
        </p:nvSpPr>
        <p:spPr>
          <a:xfrm>
            <a:off x="1349343" y="664400"/>
            <a:ext cx="158203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FD7618E-CA5A-487D-050C-6F66A940C0A5}"/>
              </a:ext>
            </a:extLst>
          </p:cNvPr>
          <p:cNvSpPr txBox="1"/>
          <p:nvPr/>
        </p:nvSpPr>
        <p:spPr>
          <a:xfrm>
            <a:off x="1525742" y="664400"/>
            <a:ext cx="158203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1BBA4F3-BC56-05D8-1DB9-55281D21B574}"/>
              </a:ext>
            </a:extLst>
          </p:cNvPr>
          <p:cNvSpPr txBox="1"/>
          <p:nvPr/>
        </p:nvSpPr>
        <p:spPr>
          <a:xfrm>
            <a:off x="1722058" y="664400"/>
            <a:ext cx="178660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145B3CC-577C-7178-A335-4EFB5612BD7F}"/>
              </a:ext>
            </a:extLst>
          </p:cNvPr>
          <p:cNvSpPr txBox="1"/>
          <p:nvPr/>
        </p:nvSpPr>
        <p:spPr>
          <a:xfrm>
            <a:off x="1898458" y="664400"/>
            <a:ext cx="178660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73FF0B4-10E9-74F1-30E5-9865138AD987}"/>
              </a:ext>
            </a:extLst>
          </p:cNvPr>
          <p:cNvSpPr txBox="1"/>
          <p:nvPr/>
        </p:nvSpPr>
        <p:spPr>
          <a:xfrm>
            <a:off x="2099781" y="1670075"/>
            <a:ext cx="262762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ACBAA6D-A906-E382-AFBA-4416D5AFAA08}"/>
              </a:ext>
            </a:extLst>
          </p:cNvPr>
          <p:cNvSpPr txBox="1"/>
          <p:nvPr/>
        </p:nvSpPr>
        <p:spPr>
          <a:xfrm>
            <a:off x="746678" y="1689576"/>
            <a:ext cx="158203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83BB5CE-DB75-4421-D022-A86E761D4787}"/>
              </a:ext>
            </a:extLst>
          </p:cNvPr>
          <p:cNvSpPr txBox="1"/>
          <p:nvPr/>
        </p:nvSpPr>
        <p:spPr>
          <a:xfrm>
            <a:off x="554089" y="1684136"/>
            <a:ext cx="178660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1E1093A-EFF5-D65E-B6CC-723394F1AE62}"/>
              </a:ext>
            </a:extLst>
          </p:cNvPr>
          <p:cNvSpPr txBox="1"/>
          <p:nvPr/>
        </p:nvSpPr>
        <p:spPr>
          <a:xfrm>
            <a:off x="1139370" y="1686010"/>
            <a:ext cx="158203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713D822-0126-3201-2896-9958D52D32A6}"/>
              </a:ext>
            </a:extLst>
          </p:cNvPr>
          <p:cNvSpPr txBox="1"/>
          <p:nvPr/>
        </p:nvSpPr>
        <p:spPr>
          <a:xfrm>
            <a:off x="946782" y="1680570"/>
            <a:ext cx="178660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368ED67-87AD-697B-F482-C394BD24A5A5}"/>
              </a:ext>
            </a:extLst>
          </p:cNvPr>
          <p:cNvSpPr txBox="1"/>
          <p:nvPr/>
        </p:nvSpPr>
        <p:spPr>
          <a:xfrm>
            <a:off x="1526427" y="1680570"/>
            <a:ext cx="158203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49F4A4B-22F0-844A-87E0-B24AAC1BD40E}"/>
              </a:ext>
            </a:extLst>
          </p:cNvPr>
          <p:cNvSpPr txBox="1"/>
          <p:nvPr/>
        </p:nvSpPr>
        <p:spPr>
          <a:xfrm>
            <a:off x="1333839" y="1675130"/>
            <a:ext cx="178660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1E9332F-BE7A-D505-5D80-D4DA12AF8E5E}"/>
              </a:ext>
            </a:extLst>
          </p:cNvPr>
          <p:cNvSpPr txBox="1"/>
          <p:nvPr/>
        </p:nvSpPr>
        <p:spPr>
          <a:xfrm>
            <a:off x="1939797" y="1684543"/>
            <a:ext cx="158203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8D6090C-0266-0A63-81F4-A1AEF93B7DE1}"/>
              </a:ext>
            </a:extLst>
          </p:cNvPr>
          <p:cNvSpPr txBox="1"/>
          <p:nvPr/>
        </p:nvSpPr>
        <p:spPr>
          <a:xfrm>
            <a:off x="1747209" y="1679103"/>
            <a:ext cx="178660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D8C7C16-61B5-A8AF-9069-8B54D996705B}"/>
              </a:ext>
            </a:extLst>
          </p:cNvPr>
          <p:cNvSpPr txBox="1"/>
          <p:nvPr/>
        </p:nvSpPr>
        <p:spPr>
          <a:xfrm>
            <a:off x="298330" y="967122"/>
            <a:ext cx="166677" cy="122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5B79CA8-C439-CE8C-9BC7-B53310A51918}"/>
              </a:ext>
            </a:extLst>
          </p:cNvPr>
          <p:cNvSpPr txBox="1"/>
          <p:nvPr/>
        </p:nvSpPr>
        <p:spPr>
          <a:xfrm>
            <a:off x="298330" y="1460915"/>
            <a:ext cx="221847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25CF6DC-6166-F93C-C001-9A234A31E0D2}"/>
              </a:ext>
            </a:extLst>
          </p:cNvPr>
          <p:cNvSpPr txBox="1"/>
          <p:nvPr/>
        </p:nvSpPr>
        <p:spPr>
          <a:xfrm>
            <a:off x="298330" y="1194469"/>
            <a:ext cx="166677" cy="1229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22638252-D486-5B7A-374A-304CA591DAA7}"/>
              </a:ext>
            </a:extLst>
          </p:cNvPr>
          <p:cNvCxnSpPr/>
          <p:nvPr/>
        </p:nvCxnSpPr>
        <p:spPr>
          <a:xfrm>
            <a:off x="528237" y="1087285"/>
            <a:ext cx="405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088D7D94-BCEB-9AD5-796B-93FBE56D1FE0}"/>
              </a:ext>
            </a:extLst>
          </p:cNvPr>
          <p:cNvCxnSpPr/>
          <p:nvPr/>
        </p:nvCxnSpPr>
        <p:spPr>
          <a:xfrm>
            <a:off x="528237" y="1315373"/>
            <a:ext cx="405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71C0452A-F163-0F12-0A5F-1A6C6F44948A}"/>
              </a:ext>
            </a:extLst>
          </p:cNvPr>
          <p:cNvCxnSpPr/>
          <p:nvPr/>
        </p:nvCxnSpPr>
        <p:spPr>
          <a:xfrm>
            <a:off x="528237" y="1582476"/>
            <a:ext cx="405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CB8E5984-73B5-65FD-F38A-353396AA6FB3}"/>
              </a:ext>
            </a:extLst>
          </p:cNvPr>
          <p:cNvSpPr txBox="1"/>
          <p:nvPr/>
        </p:nvSpPr>
        <p:spPr>
          <a:xfrm>
            <a:off x="513570" y="1845752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199" name="Picture 198">
            <a:extLst>
              <a:ext uri="{FF2B5EF4-FFF2-40B4-BE49-F238E27FC236}">
                <a16:creationId xmlns:a16="http://schemas.microsoft.com/office/drawing/2014/main" id="{F13ABDE3-FDAB-A008-7DAC-BBD1F6E5EB6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" t="31" r="469" b="416"/>
          <a:stretch/>
        </p:blipFill>
        <p:spPr>
          <a:xfrm rot="16200000">
            <a:off x="3008310" y="276456"/>
            <a:ext cx="3279734" cy="32152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1" name="Picture 200">
            <a:extLst>
              <a:ext uri="{FF2B5EF4-FFF2-40B4-BE49-F238E27FC236}">
                <a16:creationId xmlns:a16="http://schemas.microsoft.com/office/drawing/2014/main" id="{3E3993DF-5688-E89F-95C7-BE176DDB577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" t="295" r="-108" b="1347"/>
          <a:stretch/>
        </p:blipFill>
        <p:spPr>
          <a:xfrm rot="16200000">
            <a:off x="5535776" y="1327416"/>
            <a:ext cx="4103003" cy="19365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2" name="Rectangle 201">
            <a:extLst>
              <a:ext uri="{FF2B5EF4-FFF2-40B4-BE49-F238E27FC236}">
                <a16:creationId xmlns:a16="http://schemas.microsoft.com/office/drawing/2014/main" id="{C0092329-F041-A29C-EE38-54F4408DEE0A}"/>
              </a:ext>
            </a:extLst>
          </p:cNvPr>
          <p:cNvSpPr/>
          <p:nvPr/>
        </p:nvSpPr>
        <p:spPr>
          <a:xfrm>
            <a:off x="3534158" y="1991388"/>
            <a:ext cx="967992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3" name="Rectangle 202">
            <a:extLst>
              <a:ext uri="{FF2B5EF4-FFF2-40B4-BE49-F238E27FC236}">
                <a16:creationId xmlns:a16="http://schemas.microsoft.com/office/drawing/2014/main" id="{17F5533B-ED3D-0951-EC37-BC7422E89375}"/>
              </a:ext>
            </a:extLst>
          </p:cNvPr>
          <p:cNvSpPr/>
          <p:nvPr/>
        </p:nvSpPr>
        <p:spPr>
          <a:xfrm>
            <a:off x="3555866" y="707921"/>
            <a:ext cx="967992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4" name="Rectangle 203">
            <a:extLst>
              <a:ext uri="{FF2B5EF4-FFF2-40B4-BE49-F238E27FC236}">
                <a16:creationId xmlns:a16="http://schemas.microsoft.com/office/drawing/2014/main" id="{3411AACB-6CE0-C244-ABAC-8E384F8A65E7}"/>
              </a:ext>
            </a:extLst>
          </p:cNvPr>
          <p:cNvSpPr/>
          <p:nvPr/>
        </p:nvSpPr>
        <p:spPr>
          <a:xfrm>
            <a:off x="7039766" y="1230177"/>
            <a:ext cx="1075533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34943647-3506-A283-ECA2-C47DD20673AA}"/>
              </a:ext>
            </a:extLst>
          </p:cNvPr>
          <p:cNvSpPr txBox="1"/>
          <p:nvPr/>
        </p:nvSpPr>
        <p:spPr>
          <a:xfrm>
            <a:off x="4492409" y="677700"/>
            <a:ext cx="5662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0700A718-99B3-DC85-1E6C-AEB79853D9BA}"/>
              </a:ext>
            </a:extLst>
          </p:cNvPr>
          <p:cNvSpPr txBox="1"/>
          <p:nvPr/>
        </p:nvSpPr>
        <p:spPr>
          <a:xfrm>
            <a:off x="4521457" y="1985683"/>
            <a:ext cx="390052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29DFC928-943E-D146-B3C4-D2C4B8B9B132}"/>
              </a:ext>
            </a:extLst>
          </p:cNvPr>
          <p:cNvSpPr txBox="1"/>
          <p:nvPr/>
        </p:nvSpPr>
        <p:spPr>
          <a:xfrm>
            <a:off x="8115299" y="1212680"/>
            <a:ext cx="383233" cy="16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0" name="Picture 209">
            <a:extLst>
              <a:ext uri="{FF2B5EF4-FFF2-40B4-BE49-F238E27FC236}">
                <a16:creationId xmlns:a16="http://schemas.microsoft.com/office/drawing/2014/main" id="{8CBBB090-5BB0-831D-3AE4-D290998690B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97" t="24266" r="45795" b="54155"/>
          <a:stretch/>
        </p:blipFill>
        <p:spPr>
          <a:xfrm rot="5400000">
            <a:off x="1106452" y="5075504"/>
            <a:ext cx="339321" cy="8918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1" name="Picture 210">
            <a:extLst>
              <a:ext uri="{FF2B5EF4-FFF2-40B4-BE49-F238E27FC236}">
                <a16:creationId xmlns:a16="http://schemas.microsoft.com/office/drawing/2014/main" id="{94B0E695-A8A4-A78B-07EC-2EC4DDCDAFE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336" t="64508" r="22279" b="14547"/>
          <a:stretch/>
        </p:blipFill>
        <p:spPr>
          <a:xfrm rot="5400000">
            <a:off x="1106452" y="4683486"/>
            <a:ext cx="339321" cy="89189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2" name="TextBox 211">
            <a:extLst>
              <a:ext uri="{FF2B5EF4-FFF2-40B4-BE49-F238E27FC236}">
                <a16:creationId xmlns:a16="http://schemas.microsoft.com/office/drawing/2014/main" id="{744BD8D9-C81F-6E20-5038-1D798203BF23}"/>
              </a:ext>
            </a:extLst>
          </p:cNvPr>
          <p:cNvSpPr txBox="1"/>
          <p:nvPr/>
        </p:nvSpPr>
        <p:spPr>
          <a:xfrm>
            <a:off x="1706286" y="4999589"/>
            <a:ext cx="34160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1EB73552-4238-DD9C-F838-54F5EFA77754}"/>
              </a:ext>
            </a:extLst>
          </p:cNvPr>
          <p:cNvSpPr txBox="1"/>
          <p:nvPr/>
        </p:nvSpPr>
        <p:spPr>
          <a:xfrm>
            <a:off x="1706286" y="5406589"/>
            <a:ext cx="33562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E03A15B6-D5EF-4FCC-AFC0-9072DF5C5B7A}"/>
              </a:ext>
            </a:extLst>
          </p:cNvPr>
          <p:cNvSpPr txBox="1"/>
          <p:nvPr/>
        </p:nvSpPr>
        <p:spPr>
          <a:xfrm>
            <a:off x="433322" y="5018641"/>
            <a:ext cx="234104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215" name="Straight Connector 214">
            <a:extLst>
              <a:ext uri="{FF2B5EF4-FFF2-40B4-BE49-F238E27FC236}">
                <a16:creationId xmlns:a16="http://schemas.microsoft.com/office/drawing/2014/main" id="{D78A9DE3-9E82-6A2D-5E07-5FA748D4F6B4}"/>
              </a:ext>
            </a:extLst>
          </p:cNvPr>
          <p:cNvCxnSpPr>
            <a:cxnSpLocks/>
          </p:cNvCxnSpPr>
          <p:nvPr/>
        </p:nvCxnSpPr>
        <p:spPr>
          <a:xfrm>
            <a:off x="733133" y="5131001"/>
            <a:ext cx="616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6" name="TextBox 215">
            <a:extLst>
              <a:ext uri="{FF2B5EF4-FFF2-40B4-BE49-F238E27FC236}">
                <a16:creationId xmlns:a16="http://schemas.microsoft.com/office/drawing/2014/main" id="{4072B14A-DF76-C9AD-0106-6CCFF44044A7}"/>
              </a:ext>
            </a:extLst>
          </p:cNvPr>
          <p:cNvSpPr txBox="1"/>
          <p:nvPr/>
        </p:nvSpPr>
        <p:spPr>
          <a:xfrm>
            <a:off x="503616" y="5482375"/>
            <a:ext cx="19429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217" name="Straight Connector 216">
            <a:extLst>
              <a:ext uri="{FF2B5EF4-FFF2-40B4-BE49-F238E27FC236}">
                <a16:creationId xmlns:a16="http://schemas.microsoft.com/office/drawing/2014/main" id="{8CF7D9BA-A589-C5D4-5FE6-BD72B65F1999}"/>
              </a:ext>
            </a:extLst>
          </p:cNvPr>
          <p:cNvCxnSpPr>
            <a:cxnSpLocks/>
          </p:cNvCxnSpPr>
          <p:nvPr/>
        </p:nvCxnSpPr>
        <p:spPr>
          <a:xfrm>
            <a:off x="733133" y="5594735"/>
            <a:ext cx="616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8" name="TextBox 217">
            <a:extLst>
              <a:ext uri="{FF2B5EF4-FFF2-40B4-BE49-F238E27FC236}">
                <a16:creationId xmlns:a16="http://schemas.microsoft.com/office/drawing/2014/main" id="{1543E649-DE46-0BFC-8E2A-FC6544CB52B4}"/>
              </a:ext>
            </a:extLst>
          </p:cNvPr>
          <p:cNvSpPr txBox="1"/>
          <p:nvPr/>
        </p:nvSpPr>
        <p:spPr>
          <a:xfrm>
            <a:off x="760948" y="5674554"/>
            <a:ext cx="1205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Flag-USP43 OE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7AD46FAA-236A-B637-A8B3-E6147187A630}"/>
              </a:ext>
            </a:extLst>
          </p:cNvPr>
          <p:cNvSpPr txBox="1"/>
          <p:nvPr/>
        </p:nvSpPr>
        <p:spPr>
          <a:xfrm>
            <a:off x="781262" y="4769427"/>
            <a:ext cx="3194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5ED1710A-8D86-AF32-7657-B7D17BC6B503}"/>
              </a:ext>
            </a:extLst>
          </p:cNvPr>
          <p:cNvSpPr txBox="1"/>
          <p:nvPr/>
        </p:nvSpPr>
        <p:spPr>
          <a:xfrm>
            <a:off x="976999" y="4769427"/>
            <a:ext cx="1984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E6C59505-9820-C795-C64A-6FFA97344F64}"/>
              </a:ext>
            </a:extLst>
          </p:cNvPr>
          <p:cNvSpPr txBox="1"/>
          <p:nvPr/>
        </p:nvSpPr>
        <p:spPr>
          <a:xfrm>
            <a:off x="1087135" y="4769427"/>
            <a:ext cx="2217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C7561E32-C4F2-BE0B-B329-EE6859716FEA}"/>
              </a:ext>
            </a:extLst>
          </p:cNvPr>
          <p:cNvSpPr txBox="1"/>
          <p:nvPr/>
        </p:nvSpPr>
        <p:spPr>
          <a:xfrm>
            <a:off x="1706286" y="4769426"/>
            <a:ext cx="340605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8AD35E54-964A-A0BA-6033-68CAD7E6A89C}"/>
              </a:ext>
            </a:extLst>
          </p:cNvPr>
          <p:cNvSpPr txBox="1"/>
          <p:nvPr/>
        </p:nvSpPr>
        <p:spPr>
          <a:xfrm>
            <a:off x="1203386" y="4769427"/>
            <a:ext cx="3194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8F25F467-AF6A-A1B9-5F63-73DAB20AB69F}"/>
              </a:ext>
            </a:extLst>
          </p:cNvPr>
          <p:cNvSpPr txBox="1"/>
          <p:nvPr/>
        </p:nvSpPr>
        <p:spPr>
          <a:xfrm>
            <a:off x="1409814" y="4769427"/>
            <a:ext cx="1984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AF2A32C5-5174-11D0-097B-E8A0A8980C6D}"/>
              </a:ext>
            </a:extLst>
          </p:cNvPr>
          <p:cNvSpPr txBox="1"/>
          <p:nvPr/>
        </p:nvSpPr>
        <p:spPr>
          <a:xfrm>
            <a:off x="1509258" y="4769427"/>
            <a:ext cx="2217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226" name="Straight Connector 225">
            <a:extLst>
              <a:ext uri="{FF2B5EF4-FFF2-40B4-BE49-F238E27FC236}">
                <a16:creationId xmlns:a16="http://schemas.microsoft.com/office/drawing/2014/main" id="{32ECCA7A-12C0-9AF0-2779-4EDAA17F2D2E}"/>
              </a:ext>
            </a:extLst>
          </p:cNvPr>
          <p:cNvCxnSpPr/>
          <p:nvPr/>
        </p:nvCxnSpPr>
        <p:spPr>
          <a:xfrm>
            <a:off x="877531" y="4749266"/>
            <a:ext cx="35602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7" name="Straight Connector 226">
            <a:extLst>
              <a:ext uri="{FF2B5EF4-FFF2-40B4-BE49-F238E27FC236}">
                <a16:creationId xmlns:a16="http://schemas.microsoft.com/office/drawing/2014/main" id="{9F28A62B-AE79-B5BD-4996-99263FDFB5CD}"/>
              </a:ext>
            </a:extLst>
          </p:cNvPr>
          <p:cNvCxnSpPr/>
          <p:nvPr/>
        </p:nvCxnSpPr>
        <p:spPr>
          <a:xfrm>
            <a:off x="1299653" y="4749266"/>
            <a:ext cx="35602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8" name="TextBox 227">
            <a:extLst>
              <a:ext uri="{FF2B5EF4-FFF2-40B4-BE49-F238E27FC236}">
                <a16:creationId xmlns:a16="http://schemas.microsoft.com/office/drawing/2014/main" id="{22129532-DD6D-A647-AFE6-0D26B4466130}"/>
              </a:ext>
            </a:extLst>
          </p:cNvPr>
          <p:cNvSpPr txBox="1"/>
          <p:nvPr/>
        </p:nvSpPr>
        <p:spPr>
          <a:xfrm>
            <a:off x="1240473" y="4557215"/>
            <a:ext cx="34160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Flag IP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19ECC62E-D277-A5A1-F1CF-FC2F46523212}"/>
              </a:ext>
            </a:extLst>
          </p:cNvPr>
          <p:cNvSpPr txBox="1"/>
          <p:nvPr/>
        </p:nvSpPr>
        <p:spPr>
          <a:xfrm>
            <a:off x="824850" y="4557215"/>
            <a:ext cx="30975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s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35B92DC9-6CE8-66B0-F820-5E7CD6CFBB9A}"/>
              </a:ext>
            </a:extLst>
          </p:cNvPr>
          <p:cNvSpPr txBox="1"/>
          <p:nvPr/>
        </p:nvSpPr>
        <p:spPr>
          <a:xfrm>
            <a:off x="518192" y="426945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31" name="Picture 230">
            <a:extLst>
              <a:ext uri="{FF2B5EF4-FFF2-40B4-BE49-F238E27FC236}">
                <a16:creationId xmlns:a16="http://schemas.microsoft.com/office/drawing/2014/main" id="{A3BFED94-5E7F-D55B-4AB7-DAF8EC12F5F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82" t="1224" r="-708" b="531"/>
          <a:stretch/>
        </p:blipFill>
        <p:spPr>
          <a:xfrm rot="5400000">
            <a:off x="3068061" y="3842428"/>
            <a:ext cx="2802405" cy="28573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2" name="Picture 231">
            <a:extLst>
              <a:ext uri="{FF2B5EF4-FFF2-40B4-BE49-F238E27FC236}">
                <a16:creationId xmlns:a16="http://schemas.microsoft.com/office/drawing/2014/main" id="{C0D29F77-E0B2-9DDB-29F2-9D71EA2DABE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2" t="-2" r="420" b="576"/>
          <a:stretch/>
        </p:blipFill>
        <p:spPr>
          <a:xfrm rot="5400000">
            <a:off x="6053698" y="3674998"/>
            <a:ext cx="3144006" cy="28068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3" name="Rectangle 232">
            <a:extLst>
              <a:ext uri="{FF2B5EF4-FFF2-40B4-BE49-F238E27FC236}">
                <a16:creationId xmlns:a16="http://schemas.microsoft.com/office/drawing/2014/main" id="{601AD077-8F92-3EEA-1973-CB8B538FF460}"/>
              </a:ext>
            </a:extLst>
          </p:cNvPr>
          <p:cNvSpPr/>
          <p:nvPr/>
        </p:nvSpPr>
        <p:spPr>
          <a:xfrm>
            <a:off x="3398679" y="5820191"/>
            <a:ext cx="708502" cy="1615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4" name="Rectangle 233">
            <a:extLst>
              <a:ext uri="{FF2B5EF4-FFF2-40B4-BE49-F238E27FC236}">
                <a16:creationId xmlns:a16="http://schemas.microsoft.com/office/drawing/2014/main" id="{328C4A38-7939-3D13-866B-FA77C070CC7B}"/>
              </a:ext>
            </a:extLst>
          </p:cNvPr>
          <p:cNvSpPr/>
          <p:nvPr/>
        </p:nvSpPr>
        <p:spPr>
          <a:xfrm>
            <a:off x="7625701" y="5018641"/>
            <a:ext cx="708502" cy="1615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01A792DC-AAC7-3463-6B1A-D1FFAA84D5F9}"/>
              </a:ext>
            </a:extLst>
          </p:cNvPr>
          <p:cNvSpPr txBox="1"/>
          <p:nvPr/>
        </p:nvSpPr>
        <p:spPr>
          <a:xfrm>
            <a:off x="4150809" y="5827635"/>
            <a:ext cx="34160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6D01E27B-70CC-76EB-0114-8C0C4209545F}"/>
              </a:ext>
            </a:extLst>
          </p:cNvPr>
          <p:cNvSpPr txBox="1"/>
          <p:nvPr/>
        </p:nvSpPr>
        <p:spPr>
          <a:xfrm>
            <a:off x="8306915" y="5220261"/>
            <a:ext cx="33562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45578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60">
            <a:extLst>
              <a:ext uri="{FF2B5EF4-FFF2-40B4-BE49-F238E27FC236}">
                <a16:creationId xmlns:a16="http://schemas.microsoft.com/office/drawing/2014/main" id="{D06DC163-5217-DCF2-F4A2-F505B02F9B1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04" t="61270" r="46979" b="17793"/>
          <a:stretch/>
        </p:blipFill>
        <p:spPr>
          <a:xfrm rot="5400000">
            <a:off x="931972" y="1528370"/>
            <a:ext cx="339322" cy="8918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27DFEF6B-C499-FC9F-64E6-830737482B8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413" t="60841" r="31852" b="19715"/>
          <a:stretch/>
        </p:blipFill>
        <p:spPr>
          <a:xfrm rot="5400000">
            <a:off x="1868445" y="741266"/>
            <a:ext cx="339321" cy="8918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5D07E672-6917-3094-DF83-99DF02AEE69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45" t="62905" r="41118" b="14533"/>
          <a:stretch/>
        </p:blipFill>
        <p:spPr>
          <a:xfrm rot="5400000">
            <a:off x="931972" y="741266"/>
            <a:ext cx="339321" cy="8918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A746B0C6-D317-8FE3-0079-E613A1F94CC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25" t="24869" r="57863" b="52569"/>
          <a:stretch/>
        </p:blipFill>
        <p:spPr>
          <a:xfrm rot="5400000">
            <a:off x="1868445" y="1528368"/>
            <a:ext cx="339321" cy="8918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1D17635C-5A2B-FC13-A8A4-9F0215B42A5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07" t="64471" r="41763" b="14584"/>
          <a:stretch/>
        </p:blipFill>
        <p:spPr>
          <a:xfrm rot="5400000">
            <a:off x="1868445" y="345651"/>
            <a:ext cx="339321" cy="8918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602C8B4E-780C-7E35-97A2-CC970CAD5B5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95" t="65065" r="62175" b="13990"/>
          <a:stretch/>
        </p:blipFill>
        <p:spPr>
          <a:xfrm rot="5400000">
            <a:off x="931972" y="345651"/>
            <a:ext cx="339321" cy="8918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0A9C0664-CABA-6366-4D44-A8E99765D14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41" t="26299" r="59474" b="52756"/>
          <a:stretch/>
        </p:blipFill>
        <p:spPr>
          <a:xfrm rot="5400000">
            <a:off x="931972" y="1133145"/>
            <a:ext cx="339321" cy="8918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9FA72D85-0CCD-3947-1A55-7B70BBFA05C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17" t="26174" r="40098" b="52881"/>
          <a:stretch/>
        </p:blipFill>
        <p:spPr>
          <a:xfrm rot="5400000">
            <a:off x="1868445" y="1131824"/>
            <a:ext cx="339321" cy="8918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3D3957E6-5809-4446-A1F5-86AA84EA9B29}"/>
              </a:ext>
            </a:extLst>
          </p:cNvPr>
          <p:cNvSpPr txBox="1"/>
          <p:nvPr/>
        </p:nvSpPr>
        <p:spPr>
          <a:xfrm>
            <a:off x="616087" y="410573"/>
            <a:ext cx="218178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63C5CBC-DB48-7A15-B0ED-689EAC24DD3E}"/>
              </a:ext>
            </a:extLst>
          </p:cNvPr>
          <p:cNvSpPr txBox="1"/>
          <p:nvPr/>
        </p:nvSpPr>
        <p:spPr>
          <a:xfrm>
            <a:off x="839415" y="410573"/>
            <a:ext cx="135565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3ACC8CF-7B61-7CA1-ED21-F3160FC30E76}"/>
              </a:ext>
            </a:extLst>
          </p:cNvPr>
          <p:cNvSpPr txBox="1"/>
          <p:nvPr/>
        </p:nvSpPr>
        <p:spPr>
          <a:xfrm>
            <a:off x="911221" y="410573"/>
            <a:ext cx="151492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18F51C1-4EB4-D44B-76FF-0EE6B0745FCC}"/>
              </a:ext>
            </a:extLst>
          </p:cNvPr>
          <p:cNvSpPr txBox="1"/>
          <p:nvPr/>
        </p:nvSpPr>
        <p:spPr>
          <a:xfrm>
            <a:off x="1038211" y="410573"/>
            <a:ext cx="218178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CA0F4A3-B1DF-9486-3C8E-AA6C04DBB85C}"/>
              </a:ext>
            </a:extLst>
          </p:cNvPr>
          <p:cNvSpPr txBox="1"/>
          <p:nvPr/>
        </p:nvSpPr>
        <p:spPr>
          <a:xfrm>
            <a:off x="1261539" y="410573"/>
            <a:ext cx="135565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57244C7E-AE7F-B433-EEB1-0437462EC5FB}"/>
              </a:ext>
            </a:extLst>
          </p:cNvPr>
          <p:cNvSpPr txBox="1"/>
          <p:nvPr/>
        </p:nvSpPr>
        <p:spPr>
          <a:xfrm>
            <a:off x="1333344" y="410573"/>
            <a:ext cx="151492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D85FD2DE-C749-A2C3-D133-E6002273391E}"/>
              </a:ext>
            </a:extLst>
          </p:cNvPr>
          <p:cNvCxnSpPr/>
          <p:nvPr/>
        </p:nvCxnSpPr>
        <p:spPr>
          <a:xfrm>
            <a:off x="688626" y="422162"/>
            <a:ext cx="35602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9E498D34-8923-58AF-ED3F-820906AF8212}"/>
              </a:ext>
            </a:extLst>
          </p:cNvPr>
          <p:cNvCxnSpPr/>
          <p:nvPr/>
        </p:nvCxnSpPr>
        <p:spPr>
          <a:xfrm>
            <a:off x="1110749" y="422162"/>
            <a:ext cx="35602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ED979AA3-68EB-284C-9B4A-454416A166B8}"/>
              </a:ext>
            </a:extLst>
          </p:cNvPr>
          <p:cNvSpPr txBox="1"/>
          <p:nvPr/>
        </p:nvSpPr>
        <p:spPr>
          <a:xfrm>
            <a:off x="986626" y="229164"/>
            <a:ext cx="42919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IP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1365D60-5FF8-9EB3-8BD8-5705FB9D343F}"/>
              </a:ext>
            </a:extLst>
          </p:cNvPr>
          <p:cNvSpPr txBox="1"/>
          <p:nvPr/>
        </p:nvSpPr>
        <p:spPr>
          <a:xfrm>
            <a:off x="618631" y="229164"/>
            <a:ext cx="30975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s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69B84C7-27B7-A7AC-55E3-D76FE8E12360}"/>
              </a:ext>
            </a:extLst>
          </p:cNvPr>
          <p:cNvSpPr txBox="1"/>
          <p:nvPr/>
        </p:nvSpPr>
        <p:spPr>
          <a:xfrm>
            <a:off x="276837" y="684009"/>
            <a:ext cx="234104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C1013EF6-4FDB-09E6-DA4D-BBE6B434EF30}"/>
              </a:ext>
            </a:extLst>
          </p:cNvPr>
          <p:cNvCxnSpPr>
            <a:cxnSpLocks/>
          </p:cNvCxnSpPr>
          <p:nvPr/>
        </p:nvCxnSpPr>
        <p:spPr>
          <a:xfrm>
            <a:off x="573721" y="804302"/>
            <a:ext cx="616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5400C8B2-50C2-6727-0E63-C918EC8D55A8}"/>
              </a:ext>
            </a:extLst>
          </p:cNvPr>
          <p:cNvSpPr txBox="1"/>
          <p:nvPr/>
        </p:nvSpPr>
        <p:spPr>
          <a:xfrm>
            <a:off x="330349" y="1147744"/>
            <a:ext cx="19429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D227D65B-8E53-3DE9-FAF5-84EDB42E192A}"/>
              </a:ext>
            </a:extLst>
          </p:cNvPr>
          <p:cNvCxnSpPr>
            <a:cxnSpLocks/>
          </p:cNvCxnSpPr>
          <p:nvPr/>
        </p:nvCxnSpPr>
        <p:spPr>
          <a:xfrm>
            <a:off x="573721" y="1268037"/>
            <a:ext cx="616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C51F3D4F-D491-B90A-B9C8-5132961D35BB}"/>
              </a:ext>
            </a:extLst>
          </p:cNvPr>
          <p:cNvSpPr txBox="1"/>
          <p:nvPr/>
        </p:nvSpPr>
        <p:spPr>
          <a:xfrm>
            <a:off x="330349" y="1513354"/>
            <a:ext cx="19429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DD75DE5C-D04E-A7F6-C2BB-D54C846095AA}"/>
              </a:ext>
            </a:extLst>
          </p:cNvPr>
          <p:cNvCxnSpPr>
            <a:cxnSpLocks/>
          </p:cNvCxnSpPr>
          <p:nvPr/>
        </p:nvCxnSpPr>
        <p:spPr>
          <a:xfrm>
            <a:off x="573721" y="1633647"/>
            <a:ext cx="616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C67E7EBC-6F87-5603-DF63-59AB2F9FF4F8}"/>
              </a:ext>
            </a:extLst>
          </p:cNvPr>
          <p:cNvSpPr txBox="1"/>
          <p:nvPr/>
        </p:nvSpPr>
        <p:spPr>
          <a:xfrm>
            <a:off x="589763" y="2150421"/>
            <a:ext cx="9693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null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9ED1829-3927-01B3-C910-F82F99129282}"/>
              </a:ext>
            </a:extLst>
          </p:cNvPr>
          <p:cNvSpPr txBox="1"/>
          <p:nvPr/>
        </p:nvSpPr>
        <p:spPr>
          <a:xfrm>
            <a:off x="1552587" y="413766"/>
            <a:ext cx="218178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BB32CF7-94E2-0A8E-1228-3C5F78B60053}"/>
              </a:ext>
            </a:extLst>
          </p:cNvPr>
          <p:cNvSpPr txBox="1"/>
          <p:nvPr/>
        </p:nvSpPr>
        <p:spPr>
          <a:xfrm>
            <a:off x="1775915" y="413766"/>
            <a:ext cx="135565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F1A126B-FA80-C723-1A86-00426AC13B06}"/>
              </a:ext>
            </a:extLst>
          </p:cNvPr>
          <p:cNvSpPr txBox="1"/>
          <p:nvPr/>
        </p:nvSpPr>
        <p:spPr>
          <a:xfrm>
            <a:off x="1847721" y="413766"/>
            <a:ext cx="151492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58F2BFC1-93F4-5955-6CAB-198E49C0CC9A}"/>
              </a:ext>
            </a:extLst>
          </p:cNvPr>
          <p:cNvSpPr txBox="1"/>
          <p:nvPr/>
        </p:nvSpPr>
        <p:spPr>
          <a:xfrm>
            <a:off x="2459647" y="413766"/>
            <a:ext cx="340605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25A529AB-B5C8-5B32-D696-57C03A82E2DF}"/>
              </a:ext>
            </a:extLst>
          </p:cNvPr>
          <p:cNvSpPr txBox="1"/>
          <p:nvPr/>
        </p:nvSpPr>
        <p:spPr>
          <a:xfrm>
            <a:off x="1974711" y="413766"/>
            <a:ext cx="218178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E5935429-8AEE-01F6-D13D-AE8D6536A072}"/>
              </a:ext>
            </a:extLst>
          </p:cNvPr>
          <p:cNvSpPr txBox="1"/>
          <p:nvPr/>
        </p:nvSpPr>
        <p:spPr>
          <a:xfrm>
            <a:off x="2198039" y="413766"/>
            <a:ext cx="135565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1680F91-FE20-6A21-389E-E65F24B94FB8}"/>
              </a:ext>
            </a:extLst>
          </p:cNvPr>
          <p:cNvSpPr txBox="1"/>
          <p:nvPr/>
        </p:nvSpPr>
        <p:spPr>
          <a:xfrm>
            <a:off x="2269844" y="413766"/>
            <a:ext cx="151492" cy="1471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F69551F-420D-FAF6-88A3-6756BC517966}"/>
              </a:ext>
            </a:extLst>
          </p:cNvPr>
          <p:cNvSpPr txBox="1"/>
          <p:nvPr/>
        </p:nvSpPr>
        <p:spPr>
          <a:xfrm>
            <a:off x="2459647" y="738004"/>
            <a:ext cx="34160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8CF27C7E-6988-6432-ECC7-CDAD27A3CB94}"/>
              </a:ext>
            </a:extLst>
          </p:cNvPr>
          <p:cNvSpPr txBox="1"/>
          <p:nvPr/>
        </p:nvSpPr>
        <p:spPr>
          <a:xfrm>
            <a:off x="2459647" y="1102136"/>
            <a:ext cx="33562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A0A7AD69-0602-A778-DC89-FE38CA28065E}"/>
              </a:ext>
            </a:extLst>
          </p:cNvPr>
          <p:cNvSpPr txBox="1"/>
          <p:nvPr/>
        </p:nvSpPr>
        <p:spPr>
          <a:xfrm>
            <a:off x="2459647" y="1497854"/>
            <a:ext cx="33562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34F6B96B-9633-2D67-5619-BCD3B118C8C2}"/>
              </a:ext>
            </a:extLst>
          </p:cNvPr>
          <p:cNvCxnSpPr/>
          <p:nvPr/>
        </p:nvCxnSpPr>
        <p:spPr>
          <a:xfrm>
            <a:off x="1625126" y="425355"/>
            <a:ext cx="35602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6F9E2D08-821D-810C-A617-39C783C5B0FC}"/>
              </a:ext>
            </a:extLst>
          </p:cNvPr>
          <p:cNvCxnSpPr/>
          <p:nvPr/>
        </p:nvCxnSpPr>
        <p:spPr>
          <a:xfrm>
            <a:off x="2047250" y="425355"/>
            <a:ext cx="35602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863BF1DD-778A-52C1-EAFE-D1DF6D963257}"/>
              </a:ext>
            </a:extLst>
          </p:cNvPr>
          <p:cNvSpPr txBox="1"/>
          <p:nvPr/>
        </p:nvSpPr>
        <p:spPr>
          <a:xfrm>
            <a:off x="1923126" y="232357"/>
            <a:ext cx="42919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IP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F2BA4D77-2F1F-F8E5-A353-B2AC557B9E0C}"/>
              </a:ext>
            </a:extLst>
          </p:cNvPr>
          <p:cNvSpPr txBox="1"/>
          <p:nvPr/>
        </p:nvSpPr>
        <p:spPr>
          <a:xfrm>
            <a:off x="1555132" y="232357"/>
            <a:ext cx="30975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s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8FCF06B6-796B-D867-614F-A2A499715A7A}"/>
              </a:ext>
            </a:extLst>
          </p:cNvPr>
          <p:cNvSpPr txBox="1"/>
          <p:nvPr/>
        </p:nvSpPr>
        <p:spPr>
          <a:xfrm>
            <a:off x="1526263" y="2153615"/>
            <a:ext cx="9329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null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474A4938-3EEA-129C-5A62-055DE54FB720}"/>
              </a:ext>
            </a:extLst>
          </p:cNvPr>
          <p:cNvSpPr txBox="1"/>
          <p:nvPr/>
        </p:nvSpPr>
        <p:spPr>
          <a:xfrm>
            <a:off x="330349" y="1862081"/>
            <a:ext cx="19429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35D3DB8B-5505-57A2-D82D-0682BD8C6717}"/>
              </a:ext>
            </a:extLst>
          </p:cNvPr>
          <p:cNvCxnSpPr>
            <a:cxnSpLocks/>
          </p:cNvCxnSpPr>
          <p:nvPr/>
        </p:nvCxnSpPr>
        <p:spPr>
          <a:xfrm>
            <a:off x="573479" y="1977712"/>
            <a:ext cx="616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6CF33FD0-A923-4DA1-373F-B8E9B2109EFC}"/>
              </a:ext>
            </a:extLst>
          </p:cNvPr>
          <p:cNvSpPr txBox="1"/>
          <p:nvPr/>
        </p:nvSpPr>
        <p:spPr>
          <a:xfrm>
            <a:off x="2459647" y="1846583"/>
            <a:ext cx="310745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4D6CA037-A611-36AD-29FF-D887C5F3B3E5}"/>
              </a:ext>
            </a:extLst>
          </p:cNvPr>
          <p:cNvSpPr txBox="1"/>
          <p:nvPr/>
        </p:nvSpPr>
        <p:spPr>
          <a:xfrm>
            <a:off x="221145" y="20364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B02B5DFE-50E9-BF8E-1858-850FB29FA660}"/>
              </a:ext>
            </a:extLst>
          </p:cNvPr>
          <p:cNvSpPr txBox="1"/>
          <p:nvPr/>
        </p:nvSpPr>
        <p:spPr>
          <a:xfrm>
            <a:off x="2484635" y="2003858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199" name="Picture 198">
            <a:extLst>
              <a:ext uri="{FF2B5EF4-FFF2-40B4-BE49-F238E27FC236}">
                <a16:creationId xmlns:a16="http://schemas.microsoft.com/office/drawing/2014/main" id="{9478C0A6-EBF8-C4C2-F7F8-67C12ECF8D0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58" t="382" r="627" b="-390"/>
          <a:stretch/>
        </p:blipFill>
        <p:spPr>
          <a:xfrm rot="5400000">
            <a:off x="3294401" y="137842"/>
            <a:ext cx="2851702" cy="29086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1" name="Picture 200">
            <a:extLst>
              <a:ext uri="{FF2B5EF4-FFF2-40B4-BE49-F238E27FC236}">
                <a16:creationId xmlns:a16="http://schemas.microsoft.com/office/drawing/2014/main" id="{550A45D9-8FE8-4945-F4D6-AEFE058FCB1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6" t="1047" r="1118" b="1094"/>
          <a:stretch/>
        </p:blipFill>
        <p:spPr>
          <a:xfrm rot="5400000">
            <a:off x="6455591" y="642"/>
            <a:ext cx="2310819" cy="26422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2" name="Picture 201">
            <a:extLst>
              <a:ext uri="{FF2B5EF4-FFF2-40B4-BE49-F238E27FC236}">
                <a16:creationId xmlns:a16="http://schemas.microsoft.com/office/drawing/2014/main" id="{42C0F5A6-925D-B695-6B9B-6A7194EF37D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2" t="701" r="165" b="-128"/>
          <a:stretch/>
        </p:blipFill>
        <p:spPr>
          <a:xfrm rot="5400000">
            <a:off x="9400558" y="-235767"/>
            <a:ext cx="2332633" cy="31150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3" name="Picture 202">
            <a:extLst>
              <a:ext uri="{FF2B5EF4-FFF2-40B4-BE49-F238E27FC236}">
                <a16:creationId xmlns:a16="http://schemas.microsoft.com/office/drawing/2014/main" id="{A5CC7063-6DE9-197A-EEDD-B6FE2AEF3BF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09" t="130" r="1192" b="-220"/>
          <a:stretch/>
        </p:blipFill>
        <p:spPr>
          <a:xfrm rot="5400000">
            <a:off x="150939" y="3532982"/>
            <a:ext cx="2750648" cy="29110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5" name="Picture 204">
            <a:extLst>
              <a:ext uri="{FF2B5EF4-FFF2-40B4-BE49-F238E27FC236}">
                <a16:creationId xmlns:a16="http://schemas.microsoft.com/office/drawing/2014/main" id="{0C127B30-D2B2-DAE3-256C-296C9B941BA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37" t="114" r="239" b="-1175"/>
          <a:stretch/>
        </p:blipFill>
        <p:spPr>
          <a:xfrm rot="5400000">
            <a:off x="3242465" y="3418665"/>
            <a:ext cx="2919761" cy="29404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6" name="Picture 205">
            <a:extLst>
              <a:ext uri="{FF2B5EF4-FFF2-40B4-BE49-F238E27FC236}">
                <a16:creationId xmlns:a16="http://schemas.microsoft.com/office/drawing/2014/main" id="{2AA67403-9519-E093-7FF6-FDC841145FF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9" t="1287" r="738" b="727"/>
          <a:stretch/>
        </p:blipFill>
        <p:spPr>
          <a:xfrm rot="5400000">
            <a:off x="6440662" y="3278238"/>
            <a:ext cx="2899683" cy="320120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7" name="Rectangle 206">
            <a:extLst>
              <a:ext uri="{FF2B5EF4-FFF2-40B4-BE49-F238E27FC236}">
                <a16:creationId xmlns:a16="http://schemas.microsoft.com/office/drawing/2014/main" id="{608538F3-BD24-9E1E-1887-C8752401BEE3}"/>
              </a:ext>
            </a:extLst>
          </p:cNvPr>
          <p:cNvSpPr/>
          <p:nvPr/>
        </p:nvSpPr>
        <p:spPr>
          <a:xfrm>
            <a:off x="3662763" y="1102136"/>
            <a:ext cx="687601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8" name="Rectangle 207">
            <a:extLst>
              <a:ext uri="{FF2B5EF4-FFF2-40B4-BE49-F238E27FC236}">
                <a16:creationId xmlns:a16="http://schemas.microsoft.com/office/drawing/2014/main" id="{3EF4A83D-1E3F-52A1-0A4C-0601E64C9CC1}"/>
              </a:ext>
            </a:extLst>
          </p:cNvPr>
          <p:cNvSpPr/>
          <p:nvPr/>
        </p:nvSpPr>
        <p:spPr>
          <a:xfrm>
            <a:off x="3650819" y="1633647"/>
            <a:ext cx="687601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9" name="Rectangle 208">
            <a:extLst>
              <a:ext uri="{FF2B5EF4-FFF2-40B4-BE49-F238E27FC236}">
                <a16:creationId xmlns:a16="http://schemas.microsoft.com/office/drawing/2014/main" id="{4B1A33EF-6409-A848-01E4-48EC42A6381A}"/>
              </a:ext>
            </a:extLst>
          </p:cNvPr>
          <p:cNvSpPr/>
          <p:nvPr/>
        </p:nvSpPr>
        <p:spPr>
          <a:xfrm>
            <a:off x="6612651" y="1358570"/>
            <a:ext cx="687601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0" name="Rectangle 209">
            <a:extLst>
              <a:ext uri="{FF2B5EF4-FFF2-40B4-BE49-F238E27FC236}">
                <a16:creationId xmlns:a16="http://schemas.microsoft.com/office/drawing/2014/main" id="{4E195BCC-FBEE-4D9B-A1DC-E915C2E8178C}"/>
              </a:ext>
            </a:extLst>
          </p:cNvPr>
          <p:cNvSpPr/>
          <p:nvPr/>
        </p:nvSpPr>
        <p:spPr>
          <a:xfrm>
            <a:off x="9603501" y="1546424"/>
            <a:ext cx="687601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1" name="Rectangle 210">
            <a:extLst>
              <a:ext uri="{FF2B5EF4-FFF2-40B4-BE49-F238E27FC236}">
                <a16:creationId xmlns:a16="http://schemas.microsoft.com/office/drawing/2014/main" id="{2D64D4C6-35E5-E189-9599-4602D62C7808}"/>
              </a:ext>
            </a:extLst>
          </p:cNvPr>
          <p:cNvSpPr/>
          <p:nvPr/>
        </p:nvSpPr>
        <p:spPr>
          <a:xfrm>
            <a:off x="1592159" y="4573787"/>
            <a:ext cx="687601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2" name="Rectangle 211">
            <a:extLst>
              <a:ext uri="{FF2B5EF4-FFF2-40B4-BE49-F238E27FC236}">
                <a16:creationId xmlns:a16="http://schemas.microsoft.com/office/drawing/2014/main" id="{16131E22-A6DA-BECA-C4AD-78B8A44E1968}"/>
              </a:ext>
            </a:extLst>
          </p:cNvPr>
          <p:cNvSpPr/>
          <p:nvPr/>
        </p:nvSpPr>
        <p:spPr>
          <a:xfrm>
            <a:off x="1593059" y="5113237"/>
            <a:ext cx="687601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3" name="Rectangle 212">
            <a:extLst>
              <a:ext uri="{FF2B5EF4-FFF2-40B4-BE49-F238E27FC236}">
                <a16:creationId xmlns:a16="http://schemas.microsoft.com/office/drawing/2014/main" id="{39B33681-C64B-EE6D-221B-BEE864125C8C}"/>
              </a:ext>
            </a:extLst>
          </p:cNvPr>
          <p:cNvSpPr/>
          <p:nvPr/>
        </p:nvSpPr>
        <p:spPr>
          <a:xfrm>
            <a:off x="3720309" y="4821035"/>
            <a:ext cx="687601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4" name="Rectangle 213">
            <a:extLst>
              <a:ext uri="{FF2B5EF4-FFF2-40B4-BE49-F238E27FC236}">
                <a16:creationId xmlns:a16="http://schemas.microsoft.com/office/drawing/2014/main" id="{F2DDBD06-F61C-3C78-D2B2-EF98863325F7}"/>
              </a:ext>
            </a:extLst>
          </p:cNvPr>
          <p:cNvSpPr/>
          <p:nvPr/>
        </p:nvSpPr>
        <p:spPr>
          <a:xfrm>
            <a:off x="8038309" y="4375151"/>
            <a:ext cx="687601" cy="2838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1D0D78CE-F506-4D04-BC52-D37B1C70D560}"/>
              </a:ext>
            </a:extLst>
          </p:cNvPr>
          <p:cNvSpPr txBox="1"/>
          <p:nvPr/>
        </p:nvSpPr>
        <p:spPr>
          <a:xfrm>
            <a:off x="3194990" y="1100588"/>
            <a:ext cx="34160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6F26D8B8-6421-CBD5-DCEB-7446FE93213D}"/>
              </a:ext>
            </a:extLst>
          </p:cNvPr>
          <p:cNvSpPr txBox="1"/>
          <p:nvPr/>
        </p:nvSpPr>
        <p:spPr>
          <a:xfrm>
            <a:off x="3172796" y="1604508"/>
            <a:ext cx="34160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EAF1F735-53F9-660F-8AA3-750C79654241}"/>
              </a:ext>
            </a:extLst>
          </p:cNvPr>
          <p:cNvSpPr txBox="1"/>
          <p:nvPr/>
        </p:nvSpPr>
        <p:spPr>
          <a:xfrm>
            <a:off x="6673797" y="1187212"/>
            <a:ext cx="33562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7EAA07A4-E7D3-F1DB-9A0C-913DA4F93FD6}"/>
              </a:ext>
            </a:extLst>
          </p:cNvPr>
          <p:cNvSpPr txBox="1"/>
          <p:nvPr/>
        </p:nvSpPr>
        <p:spPr>
          <a:xfrm>
            <a:off x="9138619" y="1528961"/>
            <a:ext cx="33562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CCCBFEEC-8393-2079-CF1D-900F6988131E}"/>
              </a:ext>
            </a:extLst>
          </p:cNvPr>
          <p:cNvSpPr txBox="1"/>
          <p:nvPr/>
        </p:nvSpPr>
        <p:spPr>
          <a:xfrm>
            <a:off x="2237115" y="4590132"/>
            <a:ext cx="33562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C3770901-20F6-E84C-7BB9-13A430A051C1}"/>
              </a:ext>
            </a:extLst>
          </p:cNvPr>
          <p:cNvSpPr txBox="1"/>
          <p:nvPr/>
        </p:nvSpPr>
        <p:spPr>
          <a:xfrm>
            <a:off x="2253522" y="5109622"/>
            <a:ext cx="33562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21410E1E-C090-64BB-93FA-26FB0DEE5997}"/>
              </a:ext>
            </a:extLst>
          </p:cNvPr>
          <p:cNvSpPr txBox="1"/>
          <p:nvPr/>
        </p:nvSpPr>
        <p:spPr>
          <a:xfrm>
            <a:off x="3292227" y="4800011"/>
            <a:ext cx="310745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CD7BC376-9062-3730-B0F6-4C6C3C542C46}"/>
              </a:ext>
            </a:extLst>
          </p:cNvPr>
          <p:cNvSpPr txBox="1"/>
          <p:nvPr/>
        </p:nvSpPr>
        <p:spPr>
          <a:xfrm>
            <a:off x="8382109" y="4642350"/>
            <a:ext cx="310745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54221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" name="Picture 128">
            <a:extLst>
              <a:ext uri="{FF2B5EF4-FFF2-40B4-BE49-F238E27FC236}">
                <a16:creationId xmlns:a16="http://schemas.microsoft.com/office/drawing/2014/main" id="{686C8D8D-AE2F-C01B-6D4B-54515FDD3A0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68" t="38639" r="51545" b="19694"/>
          <a:stretch/>
        </p:blipFill>
        <p:spPr>
          <a:xfrm rot="5400000">
            <a:off x="1015556" y="784599"/>
            <a:ext cx="339320" cy="981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0" name="Picture 129">
            <a:extLst>
              <a:ext uri="{FF2B5EF4-FFF2-40B4-BE49-F238E27FC236}">
                <a16:creationId xmlns:a16="http://schemas.microsoft.com/office/drawing/2014/main" id="{5BDC185D-519B-6B87-40F8-E57E7DD634A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025" t="25778" r="25508" b="53556"/>
          <a:stretch/>
        </p:blipFill>
        <p:spPr>
          <a:xfrm rot="5400000">
            <a:off x="1015556" y="388879"/>
            <a:ext cx="339320" cy="981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1" name="Picture 130">
            <a:extLst>
              <a:ext uri="{FF2B5EF4-FFF2-40B4-BE49-F238E27FC236}">
                <a16:creationId xmlns:a16="http://schemas.microsoft.com/office/drawing/2014/main" id="{1F27C93D-1A02-CEEE-EE60-32D731EA33C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35" t="38195" r="34078" b="20138"/>
          <a:stretch/>
        </p:blipFill>
        <p:spPr>
          <a:xfrm rot="5400000">
            <a:off x="1015556" y="1180316"/>
            <a:ext cx="339320" cy="981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7" name="TextBox 106">
            <a:extLst>
              <a:ext uri="{FF2B5EF4-FFF2-40B4-BE49-F238E27FC236}">
                <a16:creationId xmlns:a16="http://schemas.microsoft.com/office/drawing/2014/main" id="{3A6807E1-4BEB-6BA6-1D80-228DF10D1792}"/>
              </a:ext>
            </a:extLst>
          </p:cNvPr>
          <p:cNvSpPr txBox="1"/>
          <p:nvPr/>
        </p:nvSpPr>
        <p:spPr>
          <a:xfrm>
            <a:off x="617722" y="469292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FD333C1-6617-7525-945D-8CEDE7F0A4F3}"/>
              </a:ext>
            </a:extLst>
          </p:cNvPr>
          <p:cNvSpPr txBox="1"/>
          <p:nvPr/>
        </p:nvSpPr>
        <p:spPr>
          <a:xfrm>
            <a:off x="842178" y="469292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6E0F5E8C-FD3D-78A6-0D3F-20AF10C3666D}"/>
              </a:ext>
            </a:extLst>
          </p:cNvPr>
          <p:cNvSpPr txBox="1"/>
          <p:nvPr/>
        </p:nvSpPr>
        <p:spPr>
          <a:xfrm>
            <a:off x="956394" y="469292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CE7B14B1-8A29-D7F1-A736-DA6AD172BA8F}"/>
              </a:ext>
            </a:extLst>
          </p:cNvPr>
          <p:cNvSpPr txBox="1"/>
          <p:nvPr/>
        </p:nvSpPr>
        <p:spPr>
          <a:xfrm>
            <a:off x="1646023" y="469292"/>
            <a:ext cx="412132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72B95C39-D5C6-9484-10BA-962805948B0C}"/>
              </a:ext>
            </a:extLst>
          </p:cNvPr>
          <p:cNvSpPr txBox="1"/>
          <p:nvPr/>
        </p:nvSpPr>
        <p:spPr>
          <a:xfrm>
            <a:off x="1128492" y="469292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44FEA33-ED83-6BB9-4165-892F36445CCC}"/>
              </a:ext>
            </a:extLst>
          </p:cNvPr>
          <p:cNvSpPr txBox="1"/>
          <p:nvPr/>
        </p:nvSpPr>
        <p:spPr>
          <a:xfrm>
            <a:off x="1352948" y="469292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1F976D4E-0476-F15F-1AB5-FEB413FD5AF7}"/>
              </a:ext>
            </a:extLst>
          </p:cNvPr>
          <p:cNvSpPr txBox="1"/>
          <p:nvPr/>
        </p:nvSpPr>
        <p:spPr>
          <a:xfrm>
            <a:off x="1467163" y="469292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F06D533D-51DB-7999-6C4B-711B7F221E14}"/>
              </a:ext>
            </a:extLst>
          </p:cNvPr>
          <p:cNvSpPr txBox="1"/>
          <p:nvPr/>
        </p:nvSpPr>
        <p:spPr>
          <a:xfrm>
            <a:off x="1639673" y="791028"/>
            <a:ext cx="413337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EAFC5FD4-7CCC-77BE-D22C-6703DEB0EC7B}"/>
              </a:ext>
            </a:extLst>
          </p:cNvPr>
          <p:cNvSpPr txBox="1"/>
          <p:nvPr/>
        </p:nvSpPr>
        <p:spPr>
          <a:xfrm>
            <a:off x="1639673" y="1191574"/>
            <a:ext cx="406110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E5306F16-5032-7884-3DCC-466589692774}"/>
              </a:ext>
            </a:extLst>
          </p:cNvPr>
          <p:cNvSpPr txBox="1"/>
          <p:nvPr/>
        </p:nvSpPr>
        <p:spPr>
          <a:xfrm>
            <a:off x="1639673" y="1626864"/>
            <a:ext cx="406110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CDA71E28-2493-8F7A-A3D4-2FA65D9C85EF}"/>
              </a:ext>
            </a:extLst>
          </p:cNvPr>
          <p:cNvCxnSpPr/>
          <p:nvPr/>
        </p:nvCxnSpPr>
        <p:spPr>
          <a:xfrm>
            <a:off x="687054" y="447115"/>
            <a:ext cx="43078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CDB734FD-C9B2-21F9-F6BD-63E60F738F08}"/>
              </a:ext>
            </a:extLst>
          </p:cNvPr>
          <p:cNvCxnSpPr/>
          <p:nvPr/>
        </p:nvCxnSpPr>
        <p:spPr>
          <a:xfrm>
            <a:off x="1197823" y="447115"/>
            <a:ext cx="43078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TextBox 118">
            <a:extLst>
              <a:ext uri="{FF2B5EF4-FFF2-40B4-BE49-F238E27FC236}">
                <a16:creationId xmlns:a16="http://schemas.microsoft.com/office/drawing/2014/main" id="{5F671DAA-AA0D-BAD9-049D-6D8E02560D1A}"/>
              </a:ext>
            </a:extLst>
          </p:cNvPr>
          <p:cNvSpPr txBox="1"/>
          <p:nvPr/>
        </p:nvSpPr>
        <p:spPr>
          <a:xfrm>
            <a:off x="1080653" y="268091"/>
            <a:ext cx="519320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IP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2098DCBF-F6E9-8FEC-AF07-FAA9941F89E8}"/>
              </a:ext>
            </a:extLst>
          </p:cNvPr>
          <p:cNvSpPr txBox="1"/>
          <p:nvPr/>
        </p:nvSpPr>
        <p:spPr>
          <a:xfrm>
            <a:off x="635381" y="268091"/>
            <a:ext cx="374797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s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E0ECF74A-6264-9270-0779-FBB16EDC0780}"/>
              </a:ext>
            </a:extLst>
          </p:cNvPr>
          <p:cNvSpPr txBox="1"/>
          <p:nvPr/>
        </p:nvSpPr>
        <p:spPr>
          <a:xfrm>
            <a:off x="268520" y="746577"/>
            <a:ext cx="283265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0868B7A2-013F-3298-6019-1B9271F2B973}"/>
              </a:ext>
            </a:extLst>
          </p:cNvPr>
          <p:cNvCxnSpPr>
            <a:cxnSpLocks/>
          </p:cNvCxnSpPr>
          <p:nvPr/>
        </p:nvCxnSpPr>
        <p:spPr>
          <a:xfrm>
            <a:off x="567070" y="867470"/>
            <a:ext cx="746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9F5F080E-7DC9-573D-AECE-9C88B0C9DFB5}"/>
              </a:ext>
            </a:extLst>
          </p:cNvPr>
          <p:cNvSpPr txBox="1"/>
          <p:nvPr/>
        </p:nvSpPr>
        <p:spPr>
          <a:xfrm>
            <a:off x="331365" y="1256685"/>
            <a:ext cx="235091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97FB2FB6-A547-D755-ADFB-476E36B9737C}"/>
              </a:ext>
            </a:extLst>
          </p:cNvPr>
          <p:cNvCxnSpPr>
            <a:cxnSpLocks/>
          </p:cNvCxnSpPr>
          <p:nvPr/>
        </p:nvCxnSpPr>
        <p:spPr>
          <a:xfrm>
            <a:off x="567070" y="1377578"/>
            <a:ext cx="746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348C0CA0-FDCF-B02A-5893-14EB3E38A53E}"/>
              </a:ext>
            </a:extLst>
          </p:cNvPr>
          <p:cNvSpPr txBox="1"/>
          <p:nvPr/>
        </p:nvSpPr>
        <p:spPr>
          <a:xfrm>
            <a:off x="331365" y="1658856"/>
            <a:ext cx="235091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91EBC3FE-1DDC-D68E-6BDF-E594C6BAA377}"/>
              </a:ext>
            </a:extLst>
          </p:cNvPr>
          <p:cNvCxnSpPr>
            <a:cxnSpLocks/>
          </p:cNvCxnSpPr>
          <p:nvPr/>
        </p:nvCxnSpPr>
        <p:spPr>
          <a:xfrm>
            <a:off x="567070" y="1779748"/>
            <a:ext cx="746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id="{55257AEC-0F00-8897-58BE-1EF2230B441F}"/>
              </a:ext>
            </a:extLst>
          </p:cNvPr>
          <p:cNvSpPr txBox="1"/>
          <p:nvPr/>
        </p:nvSpPr>
        <p:spPr>
          <a:xfrm>
            <a:off x="611302" y="1826290"/>
            <a:ext cx="567494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549 Cas9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C9B4DEDF-4FA6-FE0D-9765-496771FAAD92}"/>
              </a:ext>
            </a:extLst>
          </p:cNvPr>
          <p:cNvSpPr txBox="1"/>
          <p:nvPr/>
        </p:nvSpPr>
        <p:spPr>
          <a:xfrm>
            <a:off x="169333" y="20929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56" name="Picture 155">
            <a:extLst>
              <a:ext uri="{FF2B5EF4-FFF2-40B4-BE49-F238E27FC236}">
                <a16:creationId xmlns:a16="http://schemas.microsoft.com/office/drawing/2014/main" id="{38549107-231B-3101-8C38-DFA0658A25A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55" t="59660" r="71767" b="19403"/>
          <a:stretch/>
        </p:blipFill>
        <p:spPr>
          <a:xfrm rot="5400000">
            <a:off x="2882860" y="396937"/>
            <a:ext cx="339321" cy="981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7" name="Picture 156">
            <a:extLst>
              <a:ext uri="{FF2B5EF4-FFF2-40B4-BE49-F238E27FC236}">
                <a16:creationId xmlns:a16="http://schemas.microsoft.com/office/drawing/2014/main" id="{F9736D7B-1AFE-7A66-AFD1-9510864F749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69" t="63749" r="64126" b="13681"/>
          <a:stretch/>
        </p:blipFill>
        <p:spPr>
          <a:xfrm rot="5400000">
            <a:off x="2879752" y="1184134"/>
            <a:ext cx="339321" cy="9810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8" name="Picture 157">
            <a:extLst>
              <a:ext uri="{FF2B5EF4-FFF2-40B4-BE49-F238E27FC236}">
                <a16:creationId xmlns:a16="http://schemas.microsoft.com/office/drawing/2014/main" id="{840D65D0-E1E8-73F5-63B1-1CDB85A2A75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37" t="26680" r="85640" b="52416"/>
          <a:stretch/>
        </p:blipFill>
        <p:spPr>
          <a:xfrm rot="5400000">
            <a:off x="2882861" y="796590"/>
            <a:ext cx="339323" cy="981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4" name="TextBox 133">
            <a:extLst>
              <a:ext uri="{FF2B5EF4-FFF2-40B4-BE49-F238E27FC236}">
                <a16:creationId xmlns:a16="http://schemas.microsoft.com/office/drawing/2014/main" id="{8C2BCAAB-C198-FA50-B2B1-9BABC5A4E04E}"/>
              </a:ext>
            </a:extLst>
          </p:cNvPr>
          <p:cNvSpPr txBox="1"/>
          <p:nvPr/>
        </p:nvSpPr>
        <p:spPr>
          <a:xfrm>
            <a:off x="2499949" y="472580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9CDFFD3E-CF5C-DB18-6A8A-BD7D0DD783A8}"/>
              </a:ext>
            </a:extLst>
          </p:cNvPr>
          <p:cNvSpPr txBox="1"/>
          <p:nvPr/>
        </p:nvSpPr>
        <p:spPr>
          <a:xfrm>
            <a:off x="2724404" y="472580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A7CB02C0-641D-5628-8565-02FEB186A27E}"/>
              </a:ext>
            </a:extLst>
          </p:cNvPr>
          <p:cNvSpPr txBox="1"/>
          <p:nvPr/>
        </p:nvSpPr>
        <p:spPr>
          <a:xfrm>
            <a:off x="2838620" y="472580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F54F614D-ADC1-2744-925E-E338DCA5E656}"/>
              </a:ext>
            </a:extLst>
          </p:cNvPr>
          <p:cNvSpPr txBox="1"/>
          <p:nvPr/>
        </p:nvSpPr>
        <p:spPr>
          <a:xfrm>
            <a:off x="3528249" y="472579"/>
            <a:ext cx="412132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0B7CE768-36C2-7516-BEAB-EDA74898EAA5}"/>
              </a:ext>
            </a:extLst>
          </p:cNvPr>
          <p:cNvSpPr txBox="1"/>
          <p:nvPr/>
        </p:nvSpPr>
        <p:spPr>
          <a:xfrm>
            <a:off x="3010719" y="472580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186425FF-2351-AA83-0D92-01F11791AD61}"/>
              </a:ext>
            </a:extLst>
          </p:cNvPr>
          <p:cNvSpPr txBox="1"/>
          <p:nvPr/>
        </p:nvSpPr>
        <p:spPr>
          <a:xfrm>
            <a:off x="3235175" y="472580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E794ABE2-143E-ED92-6E30-107A1F39CEA4}"/>
              </a:ext>
            </a:extLst>
          </p:cNvPr>
          <p:cNvSpPr txBox="1"/>
          <p:nvPr/>
        </p:nvSpPr>
        <p:spPr>
          <a:xfrm>
            <a:off x="3349389" y="472580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E93990F3-FE08-0096-BEF7-286086D98184}"/>
              </a:ext>
            </a:extLst>
          </p:cNvPr>
          <p:cNvSpPr txBox="1"/>
          <p:nvPr/>
        </p:nvSpPr>
        <p:spPr>
          <a:xfrm>
            <a:off x="3521899" y="794315"/>
            <a:ext cx="413337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50B14CCD-4D0D-8D3C-1D2A-B8DE1EA0BF13}"/>
              </a:ext>
            </a:extLst>
          </p:cNvPr>
          <p:cNvSpPr txBox="1"/>
          <p:nvPr/>
        </p:nvSpPr>
        <p:spPr>
          <a:xfrm>
            <a:off x="3521899" y="1194862"/>
            <a:ext cx="406110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FEAF0EC6-C190-C508-BD75-38BBADBB51A7}"/>
              </a:ext>
            </a:extLst>
          </p:cNvPr>
          <p:cNvSpPr txBox="1"/>
          <p:nvPr/>
        </p:nvSpPr>
        <p:spPr>
          <a:xfrm>
            <a:off x="3521899" y="1630152"/>
            <a:ext cx="406110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BBE0D159-B33E-B787-36ED-7EA9F26F607A}"/>
              </a:ext>
            </a:extLst>
          </p:cNvPr>
          <p:cNvCxnSpPr/>
          <p:nvPr/>
        </p:nvCxnSpPr>
        <p:spPr>
          <a:xfrm>
            <a:off x="2569281" y="450403"/>
            <a:ext cx="43078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id="{0EAB00BA-4844-BBEC-5AC7-B8A8E43A05D3}"/>
              </a:ext>
            </a:extLst>
          </p:cNvPr>
          <p:cNvCxnSpPr/>
          <p:nvPr/>
        </p:nvCxnSpPr>
        <p:spPr>
          <a:xfrm>
            <a:off x="3080049" y="450403"/>
            <a:ext cx="43078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TextBox 145">
            <a:extLst>
              <a:ext uri="{FF2B5EF4-FFF2-40B4-BE49-F238E27FC236}">
                <a16:creationId xmlns:a16="http://schemas.microsoft.com/office/drawing/2014/main" id="{C03F3AE3-FBC8-5128-6090-87E33D6E42AF}"/>
              </a:ext>
            </a:extLst>
          </p:cNvPr>
          <p:cNvSpPr txBox="1"/>
          <p:nvPr/>
        </p:nvSpPr>
        <p:spPr>
          <a:xfrm>
            <a:off x="2962880" y="271379"/>
            <a:ext cx="519320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IP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4CA2B72F-C5A7-EE55-9D16-825687E5EB33}"/>
              </a:ext>
            </a:extLst>
          </p:cNvPr>
          <p:cNvSpPr txBox="1"/>
          <p:nvPr/>
        </p:nvSpPr>
        <p:spPr>
          <a:xfrm>
            <a:off x="2517608" y="271379"/>
            <a:ext cx="374797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s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32B5BCC8-437F-6880-B4A1-D485E750E00D}"/>
              </a:ext>
            </a:extLst>
          </p:cNvPr>
          <p:cNvSpPr txBox="1"/>
          <p:nvPr/>
        </p:nvSpPr>
        <p:spPr>
          <a:xfrm>
            <a:off x="2150746" y="749865"/>
            <a:ext cx="283265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2993F4BE-E6B1-B063-7031-2549778B681F}"/>
              </a:ext>
            </a:extLst>
          </p:cNvPr>
          <p:cNvCxnSpPr>
            <a:cxnSpLocks/>
          </p:cNvCxnSpPr>
          <p:nvPr/>
        </p:nvCxnSpPr>
        <p:spPr>
          <a:xfrm>
            <a:off x="2449296" y="870757"/>
            <a:ext cx="746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0" name="TextBox 149">
            <a:extLst>
              <a:ext uri="{FF2B5EF4-FFF2-40B4-BE49-F238E27FC236}">
                <a16:creationId xmlns:a16="http://schemas.microsoft.com/office/drawing/2014/main" id="{D879F31E-1DF7-FCA3-D28A-B1F01EB2B9CD}"/>
              </a:ext>
            </a:extLst>
          </p:cNvPr>
          <p:cNvSpPr txBox="1"/>
          <p:nvPr/>
        </p:nvSpPr>
        <p:spPr>
          <a:xfrm>
            <a:off x="2213591" y="1259973"/>
            <a:ext cx="235091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468A44A8-57A7-9A26-44F2-CA9DDDC6085D}"/>
              </a:ext>
            </a:extLst>
          </p:cNvPr>
          <p:cNvCxnSpPr>
            <a:cxnSpLocks/>
          </p:cNvCxnSpPr>
          <p:nvPr/>
        </p:nvCxnSpPr>
        <p:spPr>
          <a:xfrm>
            <a:off x="2449296" y="1380865"/>
            <a:ext cx="746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2" name="TextBox 151">
            <a:extLst>
              <a:ext uri="{FF2B5EF4-FFF2-40B4-BE49-F238E27FC236}">
                <a16:creationId xmlns:a16="http://schemas.microsoft.com/office/drawing/2014/main" id="{61BD46E3-D88D-DE33-52CC-36A54F73DA04}"/>
              </a:ext>
            </a:extLst>
          </p:cNvPr>
          <p:cNvSpPr txBox="1"/>
          <p:nvPr/>
        </p:nvSpPr>
        <p:spPr>
          <a:xfrm>
            <a:off x="2213591" y="1662143"/>
            <a:ext cx="235091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B4F06875-FA59-FC4B-5D7E-45A62B720FEF}"/>
              </a:ext>
            </a:extLst>
          </p:cNvPr>
          <p:cNvCxnSpPr>
            <a:cxnSpLocks/>
          </p:cNvCxnSpPr>
          <p:nvPr/>
        </p:nvCxnSpPr>
        <p:spPr>
          <a:xfrm>
            <a:off x="2449296" y="1783036"/>
            <a:ext cx="746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0D882CA0-53E5-36D9-5489-A3F63D681E6C}"/>
              </a:ext>
            </a:extLst>
          </p:cNvPr>
          <p:cNvSpPr txBox="1"/>
          <p:nvPr/>
        </p:nvSpPr>
        <p:spPr>
          <a:xfrm>
            <a:off x="2493529" y="1829578"/>
            <a:ext cx="601216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MCF7 Cas9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551CE427-AB55-A525-2C29-6B5F07A35408}"/>
              </a:ext>
            </a:extLst>
          </p:cNvPr>
          <p:cNvSpPr txBox="1"/>
          <p:nvPr/>
        </p:nvSpPr>
        <p:spPr>
          <a:xfrm>
            <a:off x="2052008" y="21733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99" name="Picture 198">
            <a:extLst>
              <a:ext uri="{FF2B5EF4-FFF2-40B4-BE49-F238E27FC236}">
                <a16:creationId xmlns:a16="http://schemas.microsoft.com/office/drawing/2014/main" id="{4AE68E31-118F-689E-A068-972B1A067DE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12" t="1505" r="531" b="553"/>
          <a:stretch/>
        </p:blipFill>
        <p:spPr>
          <a:xfrm rot="5400000">
            <a:off x="4284574" y="38990"/>
            <a:ext cx="3103215" cy="317574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0" name="Picture 199">
            <a:extLst>
              <a:ext uri="{FF2B5EF4-FFF2-40B4-BE49-F238E27FC236}">
                <a16:creationId xmlns:a16="http://schemas.microsoft.com/office/drawing/2014/main" id="{856838F5-1E82-71B8-5692-DCF84513126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38" t="1849" r="870" b="-2210"/>
          <a:stretch/>
        </p:blipFill>
        <p:spPr>
          <a:xfrm rot="5400000">
            <a:off x="6999389" y="590501"/>
            <a:ext cx="2983452" cy="19529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2" name="Picture 201">
            <a:extLst>
              <a:ext uri="{FF2B5EF4-FFF2-40B4-BE49-F238E27FC236}">
                <a16:creationId xmlns:a16="http://schemas.microsoft.com/office/drawing/2014/main" id="{D47FDF5C-0F68-BD53-B52D-2F7BFEC4ABF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59" t="502" r="591" b="-73"/>
          <a:stretch/>
        </p:blipFill>
        <p:spPr>
          <a:xfrm rot="5400000">
            <a:off x="2931352" y="2821668"/>
            <a:ext cx="2861315" cy="38559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3" name="Picture 202">
            <a:extLst>
              <a:ext uri="{FF2B5EF4-FFF2-40B4-BE49-F238E27FC236}">
                <a16:creationId xmlns:a16="http://schemas.microsoft.com/office/drawing/2014/main" id="{2A5048E8-242D-3161-C90A-30DBFAF1831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" t="227" r="464" b="302"/>
          <a:stretch/>
        </p:blipFill>
        <p:spPr>
          <a:xfrm rot="5400000">
            <a:off x="6882341" y="2818312"/>
            <a:ext cx="2864030" cy="38581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5" name="Rectangle 204">
            <a:extLst>
              <a:ext uri="{FF2B5EF4-FFF2-40B4-BE49-F238E27FC236}">
                <a16:creationId xmlns:a16="http://schemas.microsoft.com/office/drawing/2014/main" id="{2F2BF753-6B2E-D4A0-E704-3EF1DACA1BA6}"/>
              </a:ext>
            </a:extLst>
          </p:cNvPr>
          <p:cNvSpPr/>
          <p:nvPr/>
        </p:nvSpPr>
        <p:spPr>
          <a:xfrm>
            <a:off x="5946208" y="2152895"/>
            <a:ext cx="687601" cy="2647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6" name="Rectangle 205">
            <a:extLst>
              <a:ext uri="{FF2B5EF4-FFF2-40B4-BE49-F238E27FC236}">
                <a16:creationId xmlns:a16="http://schemas.microsoft.com/office/drawing/2014/main" id="{3EC435B4-224E-62FE-6755-35BBBACA3630}"/>
              </a:ext>
            </a:extLst>
          </p:cNvPr>
          <p:cNvSpPr/>
          <p:nvPr/>
        </p:nvSpPr>
        <p:spPr>
          <a:xfrm>
            <a:off x="7890017" y="1324432"/>
            <a:ext cx="839612" cy="2647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7" name="Rectangle 206">
            <a:extLst>
              <a:ext uri="{FF2B5EF4-FFF2-40B4-BE49-F238E27FC236}">
                <a16:creationId xmlns:a16="http://schemas.microsoft.com/office/drawing/2014/main" id="{2B0C1922-A9A3-8588-0E02-D6AD95F2C421}"/>
              </a:ext>
            </a:extLst>
          </p:cNvPr>
          <p:cNvSpPr/>
          <p:nvPr/>
        </p:nvSpPr>
        <p:spPr>
          <a:xfrm>
            <a:off x="7890017" y="1820775"/>
            <a:ext cx="839612" cy="2647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8" name="Rectangle 207">
            <a:extLst>
              <a:ext uri="{FF2B5EF4-FFF2-40B4-BE49-F238E27FC236}">
                <a16:creationId xmlns:a16="http://schemas.microsoft.com/office/drawing/2014/main" id="{727D6280-4F5B-1EF2-C21C-4FB7710747B6}"/>
              </a:ext>
            </a:extLst>
          </p:cNvPr>
          <p:cNvSpPr/>
          <p:nvPr/>
        </p:nvSpPr>
        <p:spPr>
          <a:xfrm>
            <a:off x="3186408" y="3867266"/>
            <a:ext cx="839612" cy="2647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9" name="Rectangle 208">
            <a:extLst>
              <a:ext uri="{FF2B5EF4-FFF2-40B4-BE49-F238E27FC236}">
                <a16:creationId xmlns:a16="http://schemas.microsoft.com/office/drawing/2014/main" id="{172BC4B0-B8B1-9187-31F0-A7AB38298EA9}"/>
              </a:ext>
            </a:extLst>
          </p:cNvPr>
          <p:cNvSpPr/>
          <p:nvPr/>
        </p:nvSpPr>
        <p:spPr>
          <a:xfrm>
            <a:off x="8309823" y="3429116"/>
            <a:ext cx="839612" cy="2647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0" name="Rectangle 209">
            <a:extLst>
              <a:ext uri="{FF2B5EF4-FFF2-40B4-BE49-F238E27FC236}">
                <a16:creationId xmlns:a16="http://schemas.microsoft.com/office/drawing/2014/main" id="{621BC416-008B-E746-0915-EB3812D47D1B}"/>
              </a:ext>
            </a:extLst>
          </p:cNvPr>
          <p:cNvSpPr/>
          <p:nvPr/>
        </p:nvSpPr>
        <p:spPr>
          <a:xfrm>
            <a:off x="6919173" y="4016812"/>
            <a:ext cx="839612" cy="2647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1F0FA391-C5CA-5F35-9693-C85B1F9098D8}"/>
              </a:ext>
            </a:extLst>
          </p:cNvPr>
          <p:cNvSpPr txBox="1"/>
          <p:nvPr/>
        </p:nvSpPr>
        <p:spPr>
          <a:xfrm>
            <a:off x="5946208" y="2464309"/>
            <a:ext cx="6876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48E20DC6-E114-7CDE-27E5-D5082FB16ECA}"/>
              </a:ext>
            </a:extLst>
          </p:cNvPr>
          <p:cNvSpPr txBox="1"/>
          <p:nvPr/>
        </p:nvSpPr>
        <p:spPr>
          <a:xfrm>
            <a:off x="4065750" y="3884210"/>
            <a:ext cx="6876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29CC507B-242A-E92B-7426-F7BB21016F4F}"/>
              </a:ext>
            </a:extLst>
          </p:cNvPr>
          <p:cNvSpPr txBox="1"/>
          <p:nvPr/>
        </p:nvSpPr>
        <p:spPr>
          <a:xfrm>
            <a:off x="8288060" y="1084233"/>
            <a:ext cx="406110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F1234951-6B38-591A-ACB3-1139EDB26896}"/>
              </a:ext>
            </a:extLst>
          </p:cNvPr>
          <p:cNvSpPr txBox="1"/>
          <p:nvPr/>
        </p:nvSpPr>
        <p:spPr>
          <a:xfrm>
            <a:off x="9244684" y="3474762"/>
            <a:ext cx="406110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D0F3C3D6-9724-3F4C-7198-343A5CFB8B42}"/>
              </a:ext>
            </a:extLst>
          </p:cNvPr>
          <p:cNvSpPr txBox="1"/>
          <p:nvPr/>
        </p:nvSpPr>
        <p:spPr>
          <a:xfrm>
            <a:off x="8289149" y="1635911"/>
            <a:ext cx="406110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8000408A-A9DD-0338-6898-70A31A1F7168}"/>
              </a:ext>
            </a:extLst>
          </p:cNvPr>
          <p:cNvSpPr txBox="1"/>
          <p:nvPr/>
        </p:nvSpPr>
        <p:spPr>
          <a:xfrm>
            <a:off x="7299094" y="3801755"/>
            <a:ext cx="406110" cy="1734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40170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Picture 159">
            <a:extLst>
              <a:ext uri="{FF2B5EF4-FFF2-40B4-BE49-F238E27FC236}">
                <a16:creationId xmlns:a16="http://schemas.microsoft.com/office/drawing/2014/main" id="{236094D7-8594-BAC8-7DC6-129DC989CD2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76" t="59113" r="55848" b="24885"/>
          <a:stretch/>
        </p:blipFill>
        <p:spPr>
          <a:xfrm rot="16200000">
            <a:off x="1319240" y="1274914"/>
            <a:ext cx="324568" cy="12171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1" name="Picture 160">
            <a:extLst>
              <a:ext uri="{FF2B5EF4-FFF2-40B4-BE49-F238E27FC236}">
                <a16:creationId xmlns:a16="http://schemas.microsoft.com/office/drawing/2014/main" id="{BC571D5C-579E-27E1-4C56-269C2F3B4A1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982" t="58949" r="15348" b="24958"/>
          <a:stretch/>
        </p:blipFill>
        <p:spPr>
          <a:xfrm rot="16200000">
            <a:off x="1327285" y="552041"/>
            <a:ext cx="324568" cy="12171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2" name="Picture 161">
            <a:extLst>
              <a:ext uri="{FF2B5EF4-FFF2-40B4-BE49-F238E27FC236}">
                <a16:creationId xmlns:a16="http://schemas.microsoft.com/office/drawing/2014/main" id="{B9BF7C34-3E32-42C7-F9DF-284A432B29E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34" t="20866" r="53068" b="47442"/>
          <a:stretch/>
        </p:blipFill>
        <p:spPr>
          <a:xfrm rot="16200000">
            <a:off x="1327285" y="191316"/>
            <a:ext cx="324568" cy="12171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3" name="Picture 162">
            <a:extLst>
              <a:ext uri="{FF2B5EF4-FFF2-40B4-BE49-F238E27FC236}">
                <a16:creationId xmlns:a16="http://schemas.microsoft.com/office/drawing/2014/main" id="{627ED0AD-072D-94C4-4617-08358420110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528" t="18013" r="15772" b="52512"/>
          <a:stretch/>
        </p:blipFill>
        <p:spPr>
          <a:xfrm rot="16200000">
            <a:off x="1327285" y="912765"/>
            <a:ext cx="324568" cy="12171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4" name="Picture 163">
            <a:extLst>
              <a:ext uri="{FF2B5EF4-FFF2-40B4-BE49-F238E27FC236}">
                <a16:creationId xmlns:a16="http://schemas.microsoft.com/office/drawing/2014/main" id="{6CBFF8D3-A8A8-89C0-69B3-5147B2D6FB2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82" t="26926" r="32583" b="43407"/>
          <a:stretch/>
        </p:blipFill>
        <p:spPr>
          <a:xfrm rot="16200000">
            <a:off x="1319240" y="1635639"/>
            <a:ext cx="324568" cy="12171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5" name="TextBox 164">
            <a:extLst>
              <a:ext uri="{FF2B5EF4-FFF2-40B4-BE49-F238E27FC236}">
                <a16:creationId xmlns:a16="http://schemas.microsoft.com/office/drawing/2014/main" id="{AF6633E6-70B7-F90E-A985-629384B52CE9}"/>
              </a:ext>
            </a:extLst>
          </p:cNvPr>
          <p:cNvSpPr txBox="1"/>
          <p:nvPr/>
        </p:nvSpPr>
        <p:spPr>
          <a:xfrm>
            <a:off x="452737" y="681857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96416024-69A7-2AC0-1D03-FFEF6BC36365}"/>
              </a:ext>
            </a:extLst>
          </p:cNvPr>
          <p:cNvSpPr txBox="1"/>
          <p:nvPr/>
        </p:nvSpPr>
        <p:spPr>
          <a:xfrm>
            <a:off x="500912" y="1107789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67C2977F-8A95-0F8C-FE60-B31C308F3E04}"/>
              </a:ext>
            </a:extLst>
          </p:cNvPr>
          <p:cNvSpPr txBox="1"/>
          <p:nvPr/>
        </p:nvSpPr>
        <p:spPr>
          <a:xfrm>
            <a:off x="500912" y="1428349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0ED9084F-2F8E-5DB9-6755-509F3A01F724}"/>
              </a:ext>
            </a:extLst>
          </p:cNvPr>
          <p:cNvSpPr txBox="1"/>
          <p:nvPr/>
        </p:nvSpPr>
        <p:spPr>
          <a:xfrm>
            <a:off x="443932" y="426027"/>
            <a:ext cx="2929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3F456F50-8C49-F6A4-4C46-2F994DA889B4}"/>
              </a:ext>
            </a:extLst>
          </p:cNvPr>
          <p:cNvSpPr txBox="1"/>
          <p:nvPr/>
        </p:nvSpPr>
        <p:spPr>
          <a:xfrm>
            <a:off x="1119258" y="394909"/>
            <a:ext cx="191036" cy="2081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-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8EF6FD6C-F5CA-9BC5-85A3-D6504B519546}"/>
              </a:ext>
            </a:extLst>
          </p:cNvPr>
          <p:cNvSpPr txBox="1"/>
          <p:nvPr/>
        </p:nvSpPr>
        <p:spPr>
          <a:xfrm>
            <a:off x="1337593" y="394909"/>
            <a:ext cx="216207" cy="2081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+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D8215FF2-E098-64A4-5572-6DFA1C6008AE}"/>
              </a:ext>
            </a:extLst>
          </p:cNvPr>
          <p:cNvSpPr txBox="1"/>
          <p:nvPr/>
        </p:nvSpPr>
        <p:spPr>
          <a:xfrm rot="16200000">
            <a:off x="120956" y="1004530"/>
            <a:ext cx="364584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5BD90758-4BDB-B4AF-97F4-EA1CE0DC0CDF}"/>
              </a:ext>
            </a:extLst>
          </p:cNvPr>
          <p:cNvSpPr txBox="1"/>
          <p:nvPr/>
        </p:nvSpPr>
        <p:spPr>
          <a:xfrm>
            <a:off x="1581099" y="394909"/>
            <a:ext cx="191036" cy="2081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-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0D8B7F1D-D534-2703-D26A-DF6B1650A048}"/>
              </a:ext>
            </a:extLst>
          </p:cNvPr>
          <p:cNvSpPr txBox="1"/>
          <p:nvPr/>
        </p:nvSpPr>
        <p:spPr>
          <a:xfrm>
            <a:off x="1799436" y="394909"/>
            <a:ext cx="216207" cy="2081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+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29B69823-621E-DA22-78BB-F8D768D97574}"/>
              </a:ext>
            </a:extLst>
          </p:cNvPr>
          <p:cNvSpPr txBox="1"/>
          <p:nvPr/>
        </p:nvSpPr>
        <p:spPr>
          <a:xfrm>
            <a:off x="912033" y="230289"/>
            <a:ext cx="459969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6C2225C8-410D-3A20-BD7A-38D941163BBD}"/>
              </a:ext>
            </a:extLst>
          </p:cNvPr>
          <p:cNvSpPr txBox="1"/>
          <p:nvPr/>
        </p:nvSpPr>
        <p:spPr>
          <a:xfrm>
            <a:off x="1395802" y="230289"/>
            <a:ext cx="562677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KO</a:t>
            </a:r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4DE83938-741E-A104-2CCD-3B4DC5FB02A0}"/>
              </a:ext>
            </a:extLst>
          </p:cNvPr>
          <p:cNvCxnSpPr/>
          <p:nvPr/>
        </p:nvCxnSpPr>
        <p:spPr>
          <a:xfrm>
            <a:off x="978708" y="414943"/>
            <a:ext cx="46684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12AA699B-B890-2FFF-79C8-0C77FF03A5DD}"/>
              </a:ext>
            </a:extLst>
          </p:cNvPr>
          <p:cNvCxnSpPr/>
          <p:nvPr/>
        </p:nvCxnSpPr>
        <p:spPr>
          <a:xfrm>
            <a:off x="1590354" y="414943"/>
            <a:ext cx="35074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8" name="TextBox 177">
            <a:extLst>
              <a:ext uri="{FF2B5EF4-FFF2-40B4-BE49-F238E27FC236}">
                <a16:creationId xmlns:a16="http://schemas.microsoft.com/office/drawing/2014/main" id="{6D7DD9E8-8DE7-C5A7-932A-66FDA0D43F3E}"/>
              </a:ext>
            </a:extLst>
          </p:cNvPr>
          <p:cNvSpPr txBox="1"/>
          <p:nvPr/>
        </p:nvSpPr>
        <p:spPr>
          <a:xfrm>
            <a:off x="2098134" y="741379"/>
            <a:ext cx="413336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B8A723F5-B94A-070A-1148-401B0E3AAE33}"/>
              </a:ext>
            </a:extLst>
          </p:cNvPr>
          <p:cNvSpPr txBox="1"/>
          <p:nvPr/>
        </p:nvSpPr>
        <p:spPr>
          <a:xfrm>
            <a:off x="2098134" y="1416883"/>
            <a:ext cx="404906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19495886-8196-5E09-7A29-73F8E1FBC8D9}"/>
              </a:ext>
            </a:extLst>
          </p:cNvPr>
          <p:cNvSpPr txBox="1"/>
          <p:nvPr/>
        </p:nvSpPr>
        <p:spPr>
          <a:xfrm>
            <a:off x="2098134" y="1126907"/>
            <a:ext cx="40611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6EF9D47B-C94E-5C73-02BF-4C7963300173}"/>
              </a:ext>
            </a:extLst>
          </p:cNvPr>
          <p:cNvSpPr txBox="1"/>
          <p:nvPr/>
        </p:nvSpPr>
        <p:spPr>
          <a:xfrm>
            <a:off x="829162" y="417680"/>
            <a:ext cx="278448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5DD6025D-EE7D-048E-E034-C841B4C1D898}"/>
              </a:ext>
            </a:extLst>
          </p:cNvPr>
          <p:cNvSpPr txBox="1"/>
          <p:nvPr/>
        </p:nvSpPr>
        <p:spPr>
          <a:xfrm>
            <a:off x="497368" y="1795867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799BE061-2DD5-CEED-3601-B7CB744D5C1E}"/>
              </a:ext>
            </a:extLst>
          </p:cNvPr>
          <p:cNvSpPr txBox="1"/>
          <p:nvPr/>
        </p:nvSpPr>
        <p:spPr>
          <a:xfrm>
            <a:off x="497368" y="2155966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7E275A33-C003-B6B5-A31C-2137860EA332}"/>
              </a:ext>
            </a:extLst>
          </p:cNvPr>
          <p:cNvSpPr txBox="1"/>
          <p:nvPr/>
        </p:nvSpPr>
        <p:spPr>
          <a:xfrm>
            <a:off x="2094590" y="2174980"/>
            <a:ext cx="37600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5949CC9A-D13A-6BF7-18D6-681298EBFFA9}"/>
              </a:ext>
            </a:extLst>
          </p:cNvPr>
          <p:cNvSpPr txBox="1"/>
          <p:nvPr/>
        </p:nvSpPr>
        <p:spPr>
          <a:xfrm>
            <a:off x="2094590" y="1801184"/>
            <a:ext cx="40611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6" name="Straight Connector 185">
            <a:extLst>
              <a:ext uri="{FF2B5EF4-FFF2-40B4-BE49-F238E27FC236}">
                <a16:creationId xmlns:a16="http://schemas.microsoft.com/office/drawing/2014/main" id="{7B0D9B28-4BF0-25B9-6B81-B1E3B26D302B}"/>
              </a:ext>
            </a:extLst>
          </p:cNvPr>
          <p:cNvCxnSpPr/>
          <p:nvPr/>
        </p:nvCxnSpPr>
        <p:spPr>
          <a:xfrm>
            <a:off x="444413" y="606076"/>
            <a:ext cx="0" cy="99121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7" name="Straight Connector 186">
            <a:extLst>
              <a:ext uri="{FF2B5EF4-FFF2-40B4-BE49-F238E27FC236}">
                <a16:creationId xmlns:a16="http://schemas.microsoft.com/office/drawing/2014/main" id="{2FCC1171-6F42-8E08-7668-E365A7D97A68}"/>
              </a:ext>
            </a:extLst>
          </p:cNvPr>
          <p:cNvCxnSpPr/>
          <p:nvPr/>
        </p:nvCxnSpPr>
        <p:spPr>
          <a:xfrm>
            <a:off x="431432" y="1722699"/>
            <a:ext cx="0" cy="67701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8" name="TextBox 187">
            <a:extLst>
              <a:ext uri="{FF2B5EF4-FFF2-40B4-BE49-F238E27FC236}">
                <a16:creationId xmlns:a16="http://schemas.microsoft.com/office/drawing/2014/main" id="{9B9D3440-AFC4-F476-A1A0-6B832EEF53B8}"/>
              </a:ext>
            </a:extLst>
          </p:cNvPr>
          <p:cNvSpPr txBox="1"/>
          <p:nvPr/>
        </p:nvSpPr>
        <p:spPr>
          <a:xfrm rot="16200000">
            <a:off x="49274" y="1983476"/>
            <a:ext cx="48198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β IP</a:t>
            </a:r>
          </a:p>
        </p:txBody>
      </p: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4EE0D152-2CC9-14EA-E6D8-94D75F76FD9E}"/>
              </a:ext>
            </a:extLst>
          </p:cNvPr>
          <p:cNvCxnSpPr>
            <a:cxnSpLocks/>
          </p:cNvCxnSpPr>
          <p:nvPr/>
        </p:nvCxnSpPr>
        <p:spPr>
          <a:xfrm>
            <a:off x="773760" y="813761"/>
            <a:ext cx="509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3F7FD141-98E9-E472-3576-2478E58A3C4C}"/>
              </a:ext>
            </a:extLst>
          </p:cNvPr>
          <p:cNvCxnSpPr>
            <a:cxnSpLocks/>
          </p:cNvCxnSpPr>
          <p:nvPr/>
        </p:nvCxnSpPr>
        <p:spPr>
          <a:xfrm>
            <a:off x="773760" y="1236597"/>
            <a:ext cx="509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FB93546A-A26A-F151-902F-C57EDD7DB677}"/>
              </a:ext>
            </a:extLst>
          </p:cNvPr>
          <p:cNvCxnSpPr>
            <a:cxnSpLocks/>
          </p:cNvCxnSpPr>
          <p:nvPr/>
        </p:nvCxnSpPr>
        <p:spPr>
          <a:xfrm>
            <a:off x="773760" y="1568536"/>
            <a:ext cx="509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6C403313-F63C-5EF0-C0B1-F27F29E4607D}"/>
              </a:ext>
            </a:extLst>
          </p:cNvPr>
          <p:cNvCxnSpPr>
            <a:cxnSpLocks/>
          </p:cNvCxnSpPr>
          <p:nvPr/>
        </p:nvCxnSpPr>
        <p:spPr>
          <a:xfrm>
            <a:off x="773760" y="1904965"/>
            <a:ext cx="509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3" name="Straight Connector 192">
            <a:extLst>
              <a:ext uri="{FF2B5EF4-FFF2-40B4-BE49-F238E27FC236}">
                <a16:creationId xmlns:a16="http://schemas.microsoft.com/office/drawing/2014/main" id="{670E379B-F767-F1D4-2ABA-C73876102265}"/>
              </a:ext>
            </a:extLst>
          </p:cNvPr>
          <p:cNvCxnSpPr>
            <a:cxnSpLocks/>
          </p:cNvCxnSpPr>
          <p:nvPr/>
        </p:nvCxnSpPr>
        <p:spPr>
          <a:xfrm>
            <a:off x="773760" y="2266868"/>
            <a:ext cx="509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4" name="TextBox 193">
            <a:extLst>
              <a:ext uri="{FF2B5EF4-FFF2-40B4-BE49-F238E27FC236}">
                <a16:creationId xmlns:a16="http://schemas.microsoft.com/office/drawing/2014/main" id="{06A08C94-5057-6B4C-A596-13BEDD830996}"/>
              </a:ext>
            </a:extLst>
          </p:cNvPr>
          <p:cNvSpPr txBox="1"/>
          <p:nvPr/>
        </p:nvSpPr>
        <p:spPr>
          <a:xfrm>
            <a:off x="2078601" y="415541"/>
            <a:ext cx="281492" cy="1184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8530426E-9234-2E7C-B2A0-48714D0C9B3A}"/>
              </a:ext>
            </a:extLst>
          </p:cNvPr>
          <p:cNvSpPr txBox="1"/>
          <p:nvPr/>
        </p:nvSpPr>
        <p:spPr>
          <a:xfrm>
            <a:off x="842904" y="2430061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A664C910-5C87-8786-7D35-13EB7DA79B8A}"/>
              </a:ext>
            </a:extLst>
          </p:cNvPr>
          <p:cNvSpPr txBox="1"/>
          <p:nvPr/>
        </p:nvSpPr>
        <p:spPr>
          <a:xfrm>
            <a:off x="165479" y="17960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199" name="Picture 198">
            <a:extLst>
              <a:ext uri="{FF2B5EF4-FFF2-40B4-BE49-F238E27FC236}">
                <a16:creationId xmlns:a16="http://schemas.microsoft.com/office/drawing/2014/main" id="{CD63CC82-1C99-3B32-7847-EAF09CE6A0A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1" t="697" r="-729" b="391"/>
          <a:stretch/>
        </p:blipFill>
        <p:spPr>
          <a:xfrm rot="16200000">
            <a:off x="2486650" y="703238"/>
            <a:ext cx="3477865" cy="23586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0" name="Picture 199">
            <a:extLst>
              <a:ext uri="{FF2B5EF4-FFF2-40B4-BE49-F238E27FC236}">
                <a16:creationId xmlns:a16="http://schemas.microsoft.com/office/drawing/2014/main" id="{997CBE0C-68E1-5168-AC90-A8F2DE19C8A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3" t="741" r="435" b="793"/>
          <a:stretch/>
        </p:blipFill>
        <p:spPr>
          <a:xfrm rot="16200000">
            <a:off x="7121217" y="-1348727"/>
            <a:ext cx="2043855" cy="50864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1" name="Picture 200">
            <a:extLst>
              <a:ext uri="{FF2B5EF4-FFF2-40B4-BE49-F238E27FC236}">
                <a16:creationId xmlns:a16="http://schemas.microsoft.com/office/drawing/2014/main" id="{AEA87B3B-A68E-FE83-401A-D8257A3ECF0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6" t="736" r="12" b="277"/>
          <a:stretch/>
        </p:blipFill>
        <p:spPr>
          <a:xfrm rot="16200000">
            <a:off x="-344293" y="3470615"/>
            <a:ext cx="3850783" cy="27918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2" name="Picture 201">
            <a:extLst>
              <a:ext uri="{FF2B5EF4-FFF2-40B4-BE49-F238E27FC236}">
                <a16:creationId xmlns:a16="http://schemas.microsoft.com/office/drawing/2014/main" id="{FB3D8A87-D9D7-15B1-AE39-9DE40A198C3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" t="46" r="-264" b="986"/>
          <a:stretch/>
        </p:blipFill>
        <p:spPr>
          <a:xfrm rot="16200000">
            <a:off x="3594473" y="3073280"/>
            <a:ext cx="3152588" cy="42490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3" name="Picture 202">
            <a:extLst>
              <a:ext uri="{FF2B5EF4-FFF2-40B4-BE49-F238E27FC236}">
                <a16:creationId xmlns:a16="http://schemas.microsoft.com/office/drawing/2014/main" id="{F6D4AD55-E3FC-38D9-02C3-A0AC947749D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1" t="1933" r="-16" b="1214"/>
          <a:stretch/>
        </p:blipFill>
        <p:spPr>
          <a:xfrm rot="16200000">
            <a:off x="6420944" y="3103720"/>
            <a:ext cx="4638968" cy="27139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4" name="Rectangle 203">
            <a:extLst>
              <a:ext uri="{FF2B5EF4-FFF2-40B4-BE49-F238E27FC236}">
                <a16:creationId xmlns:a16="http://schemas.microsoft.com/office/drawing/2014/main" id="{2EFD65EE-DE23-C3B1-3766-0AA9719C2298}"/>
              </a:ext>
            </a:extLst>
          </p:cNvPr>
          <p:cNvSpPr/>
          <p:nvPr/>
        </p:nvSpPr>
        <p:spPr>
          <a:xfrm>
            <a:off x="3543812" y="2045763"/>
            <a:ext cx="687601" cy="170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5" name="Rectangle 204">
            <a:extLst>
              <a:ext uri="{FF2B5EF4-FFF2-40B4-BE49-F238E27FC236}">
                <a16:creationId xmlns:a16="http://schemas.microsoft.com/office/drawing/2014/main" id="{F1539A40-92B1-EA91-B099-4DA80B98FA15}"/>
              </a:ext>
            </a:extLst>
          </p:cNvPr>
          <p:cNvSpPr/>
          <p:nvPr/>
        </p:nvSpPr>
        <p:spPr>
          <a:xfrm>
            <a:off x="8740428" y="456604"/>
            <a:ext cx="687601" cy="2647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6" name="Rectangle 205">
            <a:extLst>
              <a:ext uri="{FF2B5EF4-FFF2-40B4-BE49-F238E27FC236}">
                <a16:creationId xmlns:a16="http://schemas.microsoft.com/office/drawing/2014/main" id="{F6CBF8EB-73E6-252A-8A0B-E75D86A5F529}"/>
              </a:ext>
            </a:extLst>
          </p:cNvPr>
          <p:cNvSpPr/>
          <p:nvPr/>
        </p:nvSpPr>
        <p:spPr>
          <a:xfrm>
            <a:off x="671094" y="3595947"/>
            <a:ext cx="882706" cy="1697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7" name="Rectangle 206">
            <a:extLst>
              <a:ext uri="{FF2B5EF4-FFF2-40B4-BE49-F238E27FC236}">
                <a16:creationId xmlns:a16="http://schemas.microsoft.com/office/drawing/2014/main" id="{0DCBDA00-37D0-B7DE-E3C4-6C0C5BA3B3ED}"/>
              </a:ext>
            </a:extLst>
          </p:cNvPr>
          <p:cNvSpPr/>
          <p:nvPr/>
        </p:nvSpPr>
        <p:spPr>
          <a:xfrm>
            <a:off x="5495925" y="5424747"/>
            <a:ext cx="791706" cy="1759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8" name="Rectangle 207">
            <a:extLst>
              <a:ext uri="{FF2B5EF4-FFF2-40B4-BE49-F238E27FC236}">
                <a16:creationId xmlns:a16="http://schemas.microsoft.com/office/drawing/2014/main" id="{5941AD66-D082-D587-43A9-FE75470F68D8}"/>
              </a:ext>
            </a:extLst>
          </p:cNvPr>
          <p:cNvSpPr/>
          <p:nvPr/>
        </p:nvSpPr>
        <p:spPr>
          <a:xfrm>
            <a:off x="8020050" y="3727644"/>
            <a:ext cx="876700" cy="1871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D195CAFF-6F04-54B4-C53D-E454EAF70FA4}"/>
              </a:ext>
            </a:extLst>
          </p:cNvPr>
          <p:cNvSpPr txBox="1"/>
          <p:nvPr/>
        </p:nvSpPr>
        <p:spPr>
          <a:xfrm>
            <a:off x="4270886" y="2037903"/>
            <a:ext cx="413336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C9447057-003D-D451-3E65-495DB197AC20}"/>
              </a:ext>
            </a:extLst>
          </p:cNvPr>
          <p:cNvSpPr txBox="1"/>
          <p:nvPr/>
        </p:nvSpPr>
        <p:spPr>
          <a:xfrm>
            <a:off x="9448036" y="519362"/>
            <a:ext cx="40611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CD7024A0-4EDB-52BB-C41A-33408388A969}"/>
              </a:ext>
            </a:extLst>
          </p:cNvPr>
          <p:cNvSpPr txBox="1"/>
          <p:nvPr/>
        </p:nvSpPr>
        <p:spPr>
          <a:xfrm>
            <a:off x="1571720" y="3586200"/>
            <a:ext cx="404906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3DADCC6B-BD8B-85B4-5091-1C6AEBE4617E}"/>
              </a:ext>
            </a:extLst>
          </p:cNvPr>
          <p:cNvSpPr txBox="1"/>
          <p:nvPr/>
        </p:nvSpPr>
        <p:spPr>
          <a:xfrm>
            <a:off x="5789386" y="5197806"/>
            <a:ext cx="40611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C976BD2E-183D-8AB7-95C9-D9AE8C0F8FD3}"/>
              </a:ext>
            </a:extLst>
          </p:cNvPr>
          <p:cNvSpPr txBox="1"/>
          <p:nvPr/>
        </p:nvSpPr>
        <p:spPr>
          <a:xfrm>
            <a:off x="8024084" y="3509233"/>
            <a:ext cx="37600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5679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18</Words>
  <Application>Microsoft Office PowerPoint</Application>
  <PresentationFormat>Widescreen</PresentationFormat>
  <Paragraphs>15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3</cp:revision>
  <dcterms:created xsi:type="dcterms:W3CDTF">2024-03-27T11:01:34Z</dcterms:created>
  <dcterms:modified xsi:type="dcterms:W3CDTF">2024-05-10T10:12:29Z</dcterms:modified>
</cp:coreProperties>
</file>